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  <Override PartName="/ppt/changesInfos/changesInfo1.xml" ContentType="application/vnd.ms-powerpoint.changesinfo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58" r:id="rId3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8B8F41D-B794-42A0-82BE-37996429007F}" v="9" dt="2024-05-16T09:18:21.05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2628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jørnar Hassel" userId="d39901d0-36a5-4238-ad7a-36d576c03406" providerId="ADAL" clId="{F8B8F41D-B794-42A0-82BE-37996429007F}"/>
    <pc:docChg chg="undo custSel addSld modSld sldOrd">
      <pc:chgData name="Bjørnar Hassel" userId="d39901d0-36a5-4238-ad7a-36d576c03406" providerId="ADAL" clId="{F8B8F41D-B794-42A0-82BE-37996429007F}" dt="2024-05-16T09:19:18.461" v="1024" actId="255"/>
      <pc:docMkLst>
        <pc:docMk/>
      </pc:docMkLst>
      <pc:sldChg chg="addSp delSp modSp mod">
        <pc:chgData name="Bjørnar Hassel" userId="d39901d0-36a5-4238-ad7a-36d576c03406" providerId="ADAL" clId="{F8B8F41D-B794-42A0-82BE-37996429007F}" dt="2024-05-16T09:17:33.867" v="921" actId="164"/>
        <pc:sldMkLst>
          <pc:docMk/>
          <pc:sldMk cId="3546009690" sldId="258"/>
        </pc:sldMkLst>
        <pc:spChg chg="add mod">
          <ac:chgData name="Bjørnar Hassel" userId="d39901d0-36a5-4238-ad7a-36d576c03406" providerId="ADAL" clId="{F8B8F41D-B794-42A0-82BE-37996429007F}" dt="2024-05-16T09:17:33.867" v="921" actId="164"/>
          <ac:spMkLst>
            <pc:docMk/>
            <pc:sldMk cId="3546009690" sldId="258"/>
            <ac:spMk id="13" creationId="{368D1C1D-2CFD-AC1F-2124-0D4AE080DB92}"/>
          </ac:spMkLst>
        </pc:spChg>
        <pc:spChg chg="mod topLvl">
          <ac:chgData name="Bjørnar Hassel" userId="d39901d0-36a5-4238-ad7a-36d576c03406" providerId="ADAL" clId="{F8B8F41D-B794-42A0-82BE-37996429007F}" dt="2024-05-16T09:17:33.867" v="921" actId="164"/>
          <ac:spMkLst>
            <pc:docMk/>
            <pc:sldMk cId="3546009690" sldId="258"/>
            <ac:spMk id="187" creationId="{CA9D7660-580A-3942-8A21-6243390E6211}"/>
          </ac:spMkLst>
        </pc:spChg>
        <pc:spChg chg="mod topLvl">
          <ac:chgData name="Bjørnar Hassel" userId="d39901d0-36a5-4238-ad7a-36d576c03406" providerId="ADAL" clId="{F8B8F41D-B794-42A0-82BE-37996429007F}" dt="2024-05-16T09:17:33.867" v="921" actId="164"/>
          <ac:spMkLst>
            <pc:docMk/>
            <pc:sldMk cId="3546009690" sldId="258"/>
            <ac:spMk id="188" creationId="{ACE894E3-5C19-3AA8-68B0-6326931140F7}"/>
          </ac:spMkLst>
        </pc:spChg>
        <pc:spChg chg="mod topLvl">
          <ac:chgData name="Bjørnar Hassel" userId="d39901d0-36a5-4238-ad7a-36d576c03406" providerId="ADAL" clId="{F8B8F41D-B794-42A0-82BE-37996429007F}" dt="2024-05-16T09:17:33.867" v="921" actId="164"/>
          <ac:spMkLst>
            <pc:docMk/>
            <pc:sldMk cId="3546009690" sldId="258"/>
            <ac:spMk id="189" creationId="{AB426C21-C4A8-564C-26E6-93A7DA327E04}"/>
          </ac:spMkLst>
        </pc:spChg>
        <pc:spChg chg="mod topLvl">
          <ac:chgData name="Bjørnar Hassel" userId="d39901d0-36a5-4238-ad7a-36d576c03406" providerId="ADAL" clId="{F8B8F41D-B794-42A0-82BE-37996429007F}" dt="2024-05-16T09:17:33.867" v="921" actId="164"/>
          <ac:spMkLst>
            <pc:docMk/>
            <pc:sldMk cId="3546009690" sldId="258"/>
            <ac:spMk id="190" creationId="{E0E967FF-E3E1-4A81-5B43-4AEE950AAB06}"/>
          </ac:spMkLst>
        </pc:spChg>
        <pc:spChg chg="mod">
          <ac:chgData name="Bjørnar Hassel" userId="d39901d0-36a5-4238-ad7a-36d576c03406" providerId="ADAL" clId="{F8B8F41D-B794-42A0-82BE-37996429007F}" dt="2024-05-16T09:13:44.675" v="388" actId="165"/>
          <ac:spMkLst>
            <pc:docMk/>
            <pc:sldMk cId="3546009690" sldId="258"/>
            <ac:spMk id="193" creationId="{73986E32-A0D3-E38D-CFEB-254359B83ED7}"/>
          </ac:spMkLst>
        </pc:spChg>
        <pc:spChg chg="mod">
          <ac:chgData name="Bjørnar Hassel" userId="d39901d0-36a5-4238-ad7a-36d576c03406" providerId="ADAL" clId="{F8B8F41D-B794-42A0-82BE-37996429007F}" dt="2024-05-16T09:13:44.675" v="388" actId="165"/>
          <ac:spMkLst>
            <pc:docMk/>
            <pc:sldMk cId="3546009690" sldId="258"/>
            <ac:spMk id="194" creationId="{FB5B93D5-F4EA-A62D-9E28-4D33716C4EF4}"/>
          </ac:spMkLst>
        </pc:spChg>
        <pc:grpChg chg="add mod">
          <ac:chgData name="Bjørnar Hassel" userId="d39901d0-36a5-4238-ad7a-36d576c03406" providerId="ADAL" clId="{F8B8F41D-B794-42A0-82BE-37996429007F}" dt="2024-05-16T09:17:33.867" v="921" actId="164"/>
          <ac:grpSpMkLst>
            <pc:docMk/>
            <pc:sldMk cId="3546009690" sldId="258"/>
            <ac:grpSpMk id="2" creationId="{ECA77CB1-24E3-E002-96B8-3ADBB76A6E67}"/>
          </ac:grpSpMkLst>
        </pc:grpChg>
        <pc:grpChg chg="mod">
          <ac:chgData name="Bjørnar Hassel" userId="d39901d0-36a5-4238-ad7a-36d576c03406" providerId="ADAL" clId="{F8B8F41D-B794-42A0-82BE-37996429007F}" dt="2024-05-16T09:13:44.675" v="388" actId="165"/>
          <ac:grpSpMkLst>
            <pc:docMk/>
            <pc:sldMk cId="3546009690" sldId="258"/>
            <ac:grpSpMk id="15" creationId="{444390F2-4910-D481-3655-6286B2DB6971}"/>
          </ac:grpSpMkLst>
        </pc:grpChg>
        <pc:grpChg chg="mod">
          <ac:chgData name="Bjørnar Hassel" userId="d39901d0-36a5-4238-ad7a-36d576c03406" providerId="ADAL" clId="{F8B8F41D-B794-42A0-82BE-37996429007F}" dt="2024-05-16T09:13:44.675" v="388" actId="165"/>
          <ac:grpSpMkLst>
            <pc:docMk/>
            <pc:sldMk cId="3546009690" sldId="258"/>
            <ac:grpSpMk id="26" creationId="{514805E3-F452-851E-D004-D0E9839A7430}"/>
          </ac:grpSpMkLst>
        </pc:grpChg>
        <pc:grpChg chg="mod">
          <ac:chgData name="Bjørnar Hassel" userId="d39901d0-36a5-4238-ad7a-36d576c03406" providerId="ADAL" clId="{F8B8F41D-B794-42A0-82BE-37996429007F}" dt="2024-05-16T09:13:44.675" v="388" actId="165"/>
          <ac:grpSpMkLst>
            <pc:docMk/>
            <pc:sldMk cId="3546009690" sldId="258"/>
            <ac:grpSpMk id="37" creationId="{12455A17-81EA-01A2-B5A7-279432389D93}"/>
          </ac:grpSpMkLst>
        </pc:grpChg>
        <pc:grpChg chg="mod">
          <ac:chgData name="Bjørnar Hassel" userId="d39901d0-36a5-4238-ad7a-36d576c03406" providerId="ADAL" clId="{F8B8F41D-B794-42A0-82BE-37996429007F}" dt="2024-05-16T09:13:44.675" v="388" actId="165"/>
          <ac:grpSpMkLst>
            <pc:docMk/>
            <pc:sldMk cId="3546009690" sldId="258"/>
            <ac:grpSpMk id="48" creationId="{7E69553E-1E52-C160-ADCC-1C5FC8050F0F}"/>
          </ac:grpSpMkLst>
        </pc:grpChg>
        <pc:grpChg chg="mod">
          <ac:chgData name="Bjørnar Hassel" userId="d39901d0-36a5-4238-ad7a-36d576c03406" providerId="ADAL" clId="{F8B8F41D-B794-42A0-82BE-37996429007F}" dt="2024-05-16T09:13:44.675" v="388" actId="165"/>
          <ac:grpSpMkLst>
            <pc:docMk/>
            <pc:sldMk cId="3546009690" sldId="258"/>
            <ac:grpSpMk id="59" creationId="{18611903-FD2A-F454-B4CA-DB07F0DC386F}"/>
          </ac:grpSpMkLst>
        </pc:grpChg>
        <pc:grpChg chg="mod topLvl">
          <ac:chgData name="Bjørnar Hassel" userId="d39901d0-36a5-4238-ad7a-36d576c03406" providerId="ADAL" clId="{F8B8F41D-B794-42A0-82BE-37996429007F}" dt="2024-05-16T09:17:33.867" v="921" actId="164"/>
          <ac:grpSpMkLst>
            <pc:docMk/>
            <pc:sldMk cId="3546009690" sldId="258"/>
            <ac:grpSpMk id="70" creationId="{81AB49FF-5494-B30E-B10F-EEC7BBBEF9F5}"/>
          </ac:grpSpMkLst>
        </pc:grpChg>
        <pc:grpChg chg="add mod">
          <ac:chgData name="Bjørnar Hassel" userId="d39901d0-36a5-4238-ad7a-36d576c03406" providerId="ADAL" clId="{F8B8F41D-B794-42A0-82BE-37996429007F}" dt="2024-05-16T09:17:33.867" v="921" actId="164"/>
          <ac:grpSpMkLst>
            <pc:docMk/>
            <pc:sldMk cId="3546009690" sldId="258"/>
            <ac:grpSpMk id="71" creationId="{579080F4-7AE4-F69F-8B39-FF30017F7168}"/>
          </ac:grpSpMkLst>
        </pc:grpChg>
        <pc:grpChg chg="mod topLvl">
          <ac:chgData name="Bjørnar Hassel" userId="d39901d0-36a5-4238-ad7a-36d576c03406" providerId="ADAL" clId="{F8B8F41D-B794-42A0-82BE-37996429007F}" dt="2024-05-16T09:17:33.867" v="921" actId="164"/>
          <ac:grpSpMkLst>
            <pc:docMk/>
            <pc:sldMk cId="3546009690" sldId="258"/>
            <ac:grpSpMk id="128" creationId="{2BB1FF02-8A38-57E2-3C5C-C2E88E9BE864}"/>
          </ac:grpSpMkLst>
        </pc:grpChg>
        <pc:grpChg chg="mod topLvl">
          <ac:chgData name="Bjørnar Hassel" userId="d39901d0-36a5-4238-ad7a-36d576c03406" providerId="ADAL" clId="{F8B8F41D-B794-42A0-82BE-37996429007F}" dt="2024-05-16T09:17:33.867" v="921" actId="164"/>
          <ac:grpSpMkLst>
            <pc:docMk/>
            <pc:sldMk cId="3546009690" sldId="258"/>
            <ac:grpSpMk id="129" creationId="{721AD9BD-6E30-2A9F-7F14-B9029B8415CF}"/>
          </ac:grpSpMkLst>
        </pc:grpChg>
        <pc:grpChg chg="mod topLvl">
          <ac:chgData name="Bjørnar Hassel" userId="d39901d0-36a5-4238-ad7a-36d576c03406" providerId="ADAL" clId="{F8B8F41D-B794-42A0-82BE-37996429007F}" dt="2024-05-16T09:17:33.867" v="921" actId="164"/>
          <ac:grpSpMkLst>
            <pc:docMk/>
            <pc:sldMk cId="3546009690" sldId="258"/>
            <ac:grpSpMk id="130" creationId="{90840B97-B2C1-E7FD-7FFE-81A4F67EE9F4}"/>
          </ac:grpSpMkLst>
        </pc:grpChg>
        <pc:grpChg chg="mod topLvl">
          <ac:chgData name="Bjørnar Hassel" userId="d39901d0-36a5-4238-ad7a-36d576c03406" providerId="ADAL" clId="{F8B8F41D-B794-42A0-82BE-37996429007F}" dt="2024-05-16T09:17:33.867" v="921" actId="164"/>
          <ac:grpSpMkLst>
            <pc:docMk/>
            <pc:sldMk cId="3546009690" sldId="258"/>
            <ac:grpSpMk id="131" creationId="{2BA21C9E-A51A-6782-953B-B00E9E91111F}"/>
          </ac:grpSpMkLst>
        </pc:grpChg>
        <pc:grpChg chg="add del mod topLvl">
          <ac:chgData name="Bjørnar Hassel" userId="d39901d0-36a5-4238-ad7a-36d576c03406" providerId="ADAL" clId="{F8B8F41D-B794-42A0-82BE-37996429007F}" dt="2024-05-16T09:14:31.492" v="536" actId="165"/>
          <ac:grpSpMkLst>
            <pc:docMk/>
            <pc:sldMk cId="3546009690" sldId="258"/>
            <ac:grpSpMk id="183" creationId="{7E26B064-59E1-D2E5-A296-989A439E3196}"/>
          </ac:grpSpMkLst>
        </pc:grpChg>
        <pc:grpChg chg="mod topLvl">
          <ac:chgData name="Bjørnar Hassel" userId="d39901d0-36a5-4238-ad7a-36d576c03406" providerId="ADAL" clId="{F8B8F41D-B794-42A0-82BE-37996429007F}" dt="2024-05-16T09:17:33.867" v="921" actId="164"/>
          <ac:grpSpMkLst>
            <pc:docMk/>
            <pc:sldMk cId="3546009690" sldId="258"/>
            <ac:grpSpMk id="184" creationId="{AD719264-367E-CE7F-8F19-41A9E1C4FBEA}"/>
          </ac:grpSpMkLst>
        </pc:grpChg>
        <pc:grpChg chg="mod">
          <ac:chgData name="Bjørnar Hassel" userId="d39901d0-36a5-4238-ad7a-36d576c03406" providerId="ADAL" clId="{F8B8F41D-B794-42A0-82BE-37996429007F}" dt="2024-05-16T09:13:44.675" v="388" actId="165"/>
          <ac:grpSpMkLst>
            <pc:docMk/>
            <pc:sldMk cId="3546009690" sldId="258"/>
            <ac:grpSpMk id="185" creationId="{369DFDEE-78AD-D03B-F53D-E40A9A1836E1}"/>
          </ac:grpSpMkLst>
        </pc:grpChg>
        <pc:grpChg chg="mod topLvl">
          <ac:chgData name="Bjørnar Hassel" userId="d39901d0-36a5-4238-ad7a-36d576c03406" providerId="ADAL" clId="{F8B8F41D-B794-42A0-82BE-37996429007F}" dt="2024-05-16T09:17:33.867" v="921" actId="164"/>
          <ac:grpSpMkLst>
            <pc:docMk/>
            <pc:sldMk cId="3546009690" sldId="258"/>
            <ac:grpSpMk id="186" creationId="{1065B2BB-E415-7DD8-067F-16EB435EAFEE}"/>
          </ac:grpSpMkLst>
        </pc:grpChg>
        <pc:grpChg chg="mod">
          <ac:chgData name="Bjørnar Hassel" userId="d39901d0-36a5-4238-ad7a-36d576c03406" providerId="ADAL" clId="{F8B8F41D-B794-42A0-82BE-37996429007F}" dt="2024-05-16T09:13:44.675" v="388" actId="165"/>
          <ac:grpSpMkLst>
            <pc:docMk/>
            <pc:sldMk cId="3546009690" sldId="258"/>
            <ac:grpSpMk id="195" creationId="{95B61168-FC2A-7911-72C3-0624BE757951}"/>
          </ac:grpSpMkLst>
        </pc:grpChg>
        <pc:grpChg chg="mod topLvl">
          <ac:chgData name="Bjørnar Hassel" userId="d39901d0-36a5-4238-ad7a-36d576c03406" providerId="ADAL" clId="{F8B8F41D-B794-42A0-82BE-37996429007F}" dt="2024-05-16T09:17:33.867" v="921" actId="164"/>
          <ac:grpSpMkLst>
            <pc:docMk/>
            <pc:sldMk cId="3546009690" sldId="258"/>
            <ac:grpSpMk id="196" creationId="{E7351227-6AEA-B688-F84A-BFFD8C82FCB3}"/>
          </ac:grpSpMkLst>
        </pc:grpChg>
        <pc:grpChg chg="del">
          <ac:chgData name="Bjørnar Hassel" userId="d39901d0-36a5-4238-ad7a-36d576c03406" providerId="ADAL" clId="{F8B8F41D-B794-42A0-82BE-37996429007F}" dt="2024-05-16T09:13:44.675" v="388" actId="165"/>
          <ac:grpSpMkLst>
            <pc:docMk/>
            <pc:sldMk cId="3546009690" sldId="258"/>
            <ac:grpSpMk id="197" creationId="{1F383064-EA2E-C704-57A4-66679271C8AC}"/>
          </ac:grpSpMkLst>
        </pc:grpChg>
        <pc:picChg chg="mod">
          <ac:chgData name="Bjørnar Hassel" userId="d39901d0-36a5-4238-ad7a-36d576c03406" providerId="ADAL" clId="{F8B8F41D-B794-42A0-82BE-37996429007F}" dt="2024-05-16T09:14:35.744" v="537"/>
          <ac:picMkLst>
            <pc:docMk/>
            <pc:sldMk cId="3546009690" sldId="258"/>
            <ac:picMk id="3" creationId="{46CE6DD9-1083-C086-9315-FAAF2A533421}"/>
          </ac:picMkLst>
        </pc:picChg>
        <pc:picChg chg="mod">
          <ac:chgData name="Bjørnar Hassel" userId="d39901d0-36a5-4238-ad7a-36d576c03406" providerId="ADAL" clId="{F8B8F41D-B794-42A0-82BE-37996429007F}" dt="2024-05-16T09:14:35.744" v="537"/>
          <ac:picMkLst>
            <pc:docMk/>
            <pc:sldMk cId="3546009690" sldId="258"/>
            <ac:picMk id="4" creationId="{82A2EB55-F320-9D27-5888-3318E99032B1}"/>
          </ac:picMkLst>
        </pc:picChg>
        <pc:picChg chg="mod">
          <ac:chgData name="Bjørnar Hassel" userId="d39901d0-36a5-4238-ad7a-36d576c03406" providerId="ADAL" clId="{F8B8F41D-B794-42A0-82BE-37996429007F}" dt="2024-05-16T09:14:35.744" v="537"/>
          <ac:picMkLst>
            <pc:docMk/>
            <pc:sldMk cId="3546009690" sldId="258"/>
            <ac:picMk id="5" creationId="{0DA58CB3-3430-D1D4-6F8E-F080A2F4DB5D}"/>
          </ac:picMkLst>
        </pc:picChg>
        <pc:picChg chg="mod">
          <ac:chgData name="Bjørnar Hassel" userId="d39901d0-36a5-4238-ad7a-36d576c03406" providerId="ADAL" clId="{F8B8F41D-B794-42A0-82BE-37996429007F}" dt="2024-05-16T09:14:35.744" v="537"/>
          <ac:picMkLst>
            <pc:docMk/>
            <pc:sldMk cId="3546009690" sldId="258"/>
            <ac:picMk id="6" creationId="{7BEC57D2-3E42-AF04-AA3B-28C698044035}"/>
          </ac:picMkLst>
        </pc:picChg>
        <pc:picChg chg="mod">
          <ac:chgData name="Bjørnar Hassel" userId="d39901d0-36a5-4238-ad7a-36d576c03406" providerId="ADAL" clId="{F8B8F41D-B794-42A0-82BE-37996429007F}" dt="2024-05-16T09:14:35.744" v="537"/>
          <ac:picMkLst>
            <pc:docMk/>
            <pc:sldMk cId="3546009690" sldId="258"/>
            <ac:picMk id="7" creationId="{232DB0AA-63A7-03EC-6D4C-ACD3642CD290}"/>
          </ac:picMkLst>
        </pc:picChg>
        <pc:picChg chg="mod">
          <ac:chgData name="Bjørnar Hassel" userId="d39901d0-36a5-4238-ad7a-36d576c03406" providerId="ADAL" clId="{F8B8F41D-B794-42A0-82BE-37996429007F}" dt="2024-05-16T09:14:35.744" v="537"/>
          <ac:picMkLst>
            <pc:docMk/>
            <pc:sldMk cId="3546009690" sldId="258"/>
            <ac:picMk id="8" creationId="{533012F2-1E0E-036D-8777-47EF87FC4E7F}"/>
          </ac:picMkLst>
        </pc:picChg>
        <pc:picChg chg="mod">
          <ac:chgData name="Bjørnar Hassel" userId="d39901d0-36a5-4238-ad7a-36d576c03406" providerId="ADAL" clId="{F8B8F41D-B794-42A0-82BE-37996429007F}" dt="2024-05-16T09:14:35.744" v="537"/>
          <ac:picMkLst>
            <pc:docMk/>
            <pc:sldMk cId="3546009690" sldId="258"/>
            <ac:picMk id="9" creationId="{2C99F548-88D5-CB11-9513-B39327717D0E}"/>
          </ac:picMkLst>
        </pc:picChg>
        <pc:picChg chg="mod">
          <ac:chgData name="Bjørnar Hassel" userId="d39901d0-36a5-4238-ad7a-36d576c03406" providerId="ADAL" clId="{F8B8F41D-B794-42A0-82BE-37996429007F}" dt="2024-05-16T09:14:35.744" v="537"/>
          <ac:picMkLst>
            <pc:docMk/>
            <pc:sldMk cId="3546009690" sldId="258"/>
            <ac:picMk id="10" creationId="{E925326B-0943-EAF0-C939-D72FAAC735DE}"/>
          </ac:picMkLst>
        </pc:picChg>
        <pc:picChg chg="mod">
          <ac:chgData name="Bjørnar Hassel" userId="d39901d0-36a5-4238-ad7a-36d576c03406" providerId="ADAL" clId="{F8B8F41D-B794-42A0-82BE-37996429007F}" dt="2024-05-16T09:14:35.744" v="537"/>
          <ac:picMkLst>
            <pc:docMk/>
            <pc:sldMk cId="3546009690" sldId="258"/>
            <ac:picMk id="11" creationId="{18DA0AEA-8B6C-C73A-6509-D1350A4A9311}"/>
          </ac:picMkLst>
        </pc:picChg>
        <pc:picChg chg="del mod">
          <ac:chgData name="Bjørnar Hassel" userId="d39901d0-36a5-4238-ad7a-36d576c03406" providerId="ADAL" clId="{F8B8F41D-B794-42A0-82BE-37996429007F}" dt="2024-05-16T09:14:45.997" v="600" actId="478"/>
          <ac:picMkLst>
            <pc:docMk/>
            <pc:sldMk cId="3546009690" sldId="258"/>
            <ac:picMk id="12" creationId="{61EBF1BE-24A7-CB66-41F6-9252BCF0751E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16" creationId="{A163DE9F-7CFD-BC1E-F4CE-FBE1B07E672D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17" creationId="{8A755FC9-8AEA-7CB5-795D-BFEEAD44A301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18" creationId="{6546E309-E353-6889-45E4-FD4074206C63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19" creationId="{B7626880-CB58-3DFA-26A7-AFD116FA8CCB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20" creationId="{42F76A2E-1600-BB3A-7B88-CD306F3C7BFA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21" creationId="{2C3B54D1-F81F-0539-67C2-A634033588C6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22" creationId="{4160A3CC-3F9A-08DC-41B8-0D41F714C9A0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23" creationId="{2D216639-0434-DA19-F6B4-4512A7E260FA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24" creationId="{333E3041-5E32-918D-7C71-D11513E4D934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25" creationId="{C20E25D5-DDA5-3C77-6E27-956B1E6A5363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27" creationId="{087E2465-3364-55F4-10FD-955455E2B126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28" creationId="{91A19C66-721E-9640-AE2B-ABC9B927558D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29" creationId="{434899F8-2C3F-DA51-1C0E-246467ECA577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30" creationId="{AB138291-031F-8FC1-62FF-8C4B0890CBC4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31" creationId="{C84F85E6-0E92-DE38-8750-3AAECA777819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32" creationId="{36869252-2A07-49D9-8A14-DB5223088C96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33" creationId="{B2514737-8786-D17C-A7AA-8540A18892B0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34" creationId="{AAA69DB0-DE2D-8AC5-77E9-32B876A2FA56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35" creationId="{4B1693E6-023F-75C2-8D80-295E61271F54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36" creationId="{AEE56C3A-AE0A-C9E1-2203-B132FFD3894E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38" creationId="{9C88A4B4-4DC4-59CF-0063-ED8D82B9D63C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39" creationId="{D0DE6853-E96D-8E14-1F13-E9E27EA02FB8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40" creationId="{142063C4-C845-F484-42B6-2A3ADA37F8F1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41" creationId="{DD1246BA-CCA4-62B6-2FF6-B93546C3940F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42" creationId="{6D829F06-1F9F-1A31-309D-4952ED1348DA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43" creationId="{DDEE484A-5977-B93B-2EA1-E5790BE10046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44" creationId="{78FFCA89-2A0B-680F-6C94-F6ECB4E6C8BE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45" creationId="{4BD3364B-7E93-A4FE-09F8-C664F71785B2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46" creationId="{A9023196-C5CF-0634-53B8-7F8867336417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47" creationId="{E953BF0A-4A22-9EC4-D7F9-817937A19D0B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49" creationId="{B5130E10-80AD-2256-001C-9B518A05BCE9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50" creationId="{9F176444-92CD-DD52-80A0-FB89FF6DE0F4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51" creationId="{B492CFEA-55AD-D1A6-6EB0-CAEE819BAE55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52" creationId="{C3ADCD7D-C996-1445-53B8-DE73E8623A26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53" creationId="{46167485-E848-5D84-BF67-E00EC2282920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54" creationId="{70769440-4D81-7A59-496A-53472D054A05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55" creationId="{2477C30F-8C7A-852D-7B77-679D83619A82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56" creationId="{D59AAE9A-C597-F348-F29C-78BF32F14C8F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57" creationId="{CBF6B1DF-09D8-EC92-A374-BDCB56AD5C16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58" creationId="{1CC52812-9A12-3181-CDD0-FF78089F8566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60" creationId="{FCF5966D-285D-56DC-5C3F-5F9EADAD8ADD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61" creationId="{37E1C14E-7DA2-85F6-F80F-AE7D4106C2F2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62" creationId="{BDC14649-755C-9C03-1761-A1337FD2A0F7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63" creationId="{EFFE22F4-226E-3BF2-76C6-15D23D4B7525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64" creationId="{7967E989-4AF3-117C-24F1-0BC3C5EDDE11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65" creationId="{B6592BA9-D965-5AF6-C680-B5A54ABD0E2D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66" creationId="{BE2D633C-A7E2-6E7F-4C4A-2BE809311A39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67" creationId="{B1FE7CCB-A55D-3868-B188-9DAAF323EE1C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68" creationId="{4009B5F8-7269-7723-8D28-DA7847337B98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69" creationId="{644E073A-BEC9-07F7-3C67-91BB2F18AC8F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133" creationId="{F1F0144E-8B3F-35C9-CB5E-8EB10B71688E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134" creationId="{C64563AC-836B-E7CC-8074-46C53E18CAC5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135" creationId="{BE8868F1-7D99-D5D6-456C-9199F8A5D36F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136" creationId="{20BD61E9-EB30-A144-75BD-06CFDDDEFEBA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137" creationId="{6901F162-7E46-506D-813E-2F8341B6D262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138" creationId="{53A75A5B-EC63-4107-36EB-42C5C182B653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139" creationId="{CA5D28CC-3098-15D7-5C66-BAE1F58119E8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140" creationId="{18B16C1A-AD4D-E24D-FDB4-278C6C674F38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141" creationId="{58AFB398-E034-5945-3CF8-44AAA28A8DD3}"/>
          </ac:picMkLst>
        </pc:picChg>
        <pc:picChg chg="mod">
          <ac:chgData name="Bjørnar Hassel" userId="d39901d0-36a5-4238-ad7a-36d576c03406" providerId="ADAL" clId="{F8B8F41D-B794-42A0-82BE-37996429007F}" dt="2024-05-16T09:13:44.675" v="388" actId="165"/>
          <ac:picMkLst>
            <pc:docMk/>
            <pc:sldMk cId="3546009690" sldId="258"/>
            <ac:picMk id="142" creationId="{444B4324-DCA2-17C9-762B-9D06314507C4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43" creationId="{1A77D600-1384-710F-7AA7-C3218DBB5423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44" creationId="{3A977B48-E552-22C8-71EC-814FACE60835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45" creationId="{4AACC1D1-73B4-1202-F4E5-238AA417C5A9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46" creationId="{9AA7E9D5-4F0C-68F7-8333-0D7E0099EE9A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47" creationId="{C87E4BBC-EEF6-95E1-C3E3-2449EADAC6E1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48" creationId="{1FA9E6CC-BB70-A214-F412-EF71B376E5EE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49" creationId="{C030E2F2-351D-752E-5297-7F9AAD997084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50" creationId="{DF21906F-DA18-9707-2069-42F6C605480E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51" creationId="{A3822368-8BE3-2DC7-168E-4062B5E70160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52" creationId="{01D1F4E6-5D9C-F6A0-344F-1AFE689EF938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53" creationId="{A30924A5-9FCB-1DED-6AC8-D5B94F3F8810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54" creationId="{3CA2AE86-01E2-87AD-2FBD-40CBD65E442A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55" creationId="{EBB08C13-2797-6CE7-0711-9E5BA434F6CD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56" creationId="{8CBEFE35-2972-FE35-E882-6A28C2CE0A93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57" creationId="{FB6AD8A2-D145-3E3E-71A3-48FB5CF1372F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58" creationId="{DB72BC2F-FD64-6978-D778-E94AA44E892A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59" creationId="{7783C85E-39F7-6E37-D977-B1A8953A6394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60" creationId="{871E7BD6-D455-5791-7EB1-22BC4A948C7C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61" creationId="{84C345E5-F10D-838C-2FF3-179198D4CC79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62" creationId="{6AB7014F-8BEB-560B-99F7-F601BCF1E6CD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63" creationId="{A02EC1CB-3370-BCA4-D482-0206D6DA8BAD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64" creationId="{46B96C5F-51B6-644C-02B7-4014F8148880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65" creationId="{2790A332-3918-F5FD-474E-83A44B679D7C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66" creationId="{44AC9439-7CB0-9331-3F3C-F7B6E587AD8B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67" creationId="{BC07C037-1059-0E1E-C733-26D2E692AA7C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68" creationId="{5B0AD627-D61F-9737-D1D9-2ABAA6EF9299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69" creationId="{B2E00300-8D77-F98B-4897-DCA9C41E1E69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70" creationId="{6877EF22-4885-1F57-A604-6DFDF6259F95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71" creationId="{DB9DCEAC-F3E0-9CE8-379E-2C969591F007}"/>
          </ac:picMkLst>
        </pc:picChg>
        <pc:picChg chg="add del 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72" creationId="{5CAB864D-E5D6-8F48-03C8-83CE0629518D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73" creationId="{550F2D9C-9031-699F-53F9-C751DCE2AC06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74" creationId="{B0A8ACC6-6D14-B81B-975F-C23F65A698C9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75" creationId="{240C6D28-04E4-A910-BB1F-729542D9681D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76" creationId="{87DAEE29-B0D7-93E4-BFB4-DD3F10AA285F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77" creationId="{DA58F981-A653-FBD9-FBD3-F0C7FEC58E08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78" creationId="{F5FC8B16-FE5F-FF34-3826-BEF96EA13474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79" creationId="{32F2C18E-DCAA-4CD5-02EA-1DB4781B3E1C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80" creationId="{82386E32-12CD-E2A4-B95B-5F5A53E80765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81" creationId="{26AF968D-5947-743D-B4C7-BE58F9E3A47D}"/>
          </ac:picMkLst>
        </pc:picChg>
        <pc:picChg chg="mod">
          <ac:chgData name="Bjørnar Hassel" userId="d39901d0-36a5-4238-ad7a-36d576c03406" providerId="ADAL" clId="{F8B8F41D-B794-42A0-82BE-37996429007F}" dt="2024-05-16T09:14:31.492" v="536" actId="165"/>
          <ac:picMkLst>
            <pc:docMk/>
            <pc:sldMk cId="3546009690" sldId="258"/>
            <ac:picMk id="182" creationId="{CB4E8DBB-6A84-B0E6-5812-0C7590A83933}"/>
          </ac:picMkLst>
        </pc:picChg>
        <pc:cxnChg chg="add mod">
          <ac:chgData name="Bjørnar Hassel" userId="d39901d0-36a5-4238-ad7a-36d576c03406" providerId="ADAL" clId="{F8B8F41D-B794-42A0-82BE-37996429007F}" dt="2024-05-16T09:17:33.867" v="921" actId="164"/>
          <ac:cxnSpMkLst>
            <pc:docMk/>
            <pc:sldMk cId="3546009690" sldId="258"/>
            <ac:cxnSpMk id="14" creationId="{88F05834-1610-689C-ECEB-18FB568AAC36}"/>
          </ac:cxnSpMkLst>
        </pc:cxnChg>
        <pc:cxnChg chg="mod">
          <ac:chgData name="Bjørnar Hassel" userId="d39901d0-36a5-4238-ad7a-36d576c03406" providerId="ADAL" clId="{F8B8F41D-B794-42A0-82BE-37996429007F}" dt="2024-05-16T09:13:44.675" v="388" actId="165"/>
          <ac:cxnSpMkLst>
            <pc:docMk/>
            <pc:sldMk cId="3546009690" sldId="258"/>
            <ac:cxnSpMk id="192" creationId="{ECF74AD7-742B-2BEC-B79F-1DEA9889172B}"/>
          </ac:cxnSpMkLst>
        </pc:cxnChg>
      </pc:sldChg>
      <pc:sldChg chg="addSp delSp modSp new mod ord">
        <pc:chgData name="Bjørnar Hassel" userId="d39901d0-36a5-4238-ad7a-36d576c03406" providerId="ADAL" clId="{F8B8F41D-B794-42A0-82BE-37996429007F}" dt="2024-05-16T09:19:18.461" v="1024" actId="255"/>
        <pc:sldMkLst>
          <pc:docMk/>
          <pc:sldMk cId="79386092" sldId="259"/>
        </pc:sldMkLst>
        <pc:spChg chg="del">
          <ac:chgData name="Bjørnar Hassel" userId="d39901d0-36a5-4238-ad7a-36d576c03406" providerId="ADAL" clId="{F8B8F41D-B794-42A0-82BE-37996429007F}" dt="2024-05-16T09:10:36.779" v="44" actId="478"/>
          <ac:spMkLst>
            <pc:docMk/>
            <pc:sldMk cId="79386092" sldId="259"/>
            <ac:spMk id="2" creationId="{A9808734-3D72-88A3-F8BB-60B52D2D24A1}"/>
          </ac:spMkLst>
        </pc:spChg>
        <pc:spChg chg="del">
          <ac:chgData name="Bjørnar Hassel" userId="d39901d0-36a5-4238-ad7a-36d576c03406" providerId="ADAL" clId="{F8B8F41D-B794-42A0-82BE-37996429007F}" dt="2024-05-16T09:10:36.779" v="44" actId="478"/>
          <ac:spMkLst>
            <pc:docMk/>
            <pc:sldMk cId="79386092" sldId="259"/>
            <ac:spMk id="3" creationId="{F08267C3-E5F6-3E8A-C8E4-480B3B56BE2E}"/>
          </ac:spMkLst>
        </pc:spChg>
        <pc:spChg chg="add mod">
          <ac:chgData name="Bjørnar Hassel" userId="d39901d0-36a5-4238-ad7a-36d576c03406" providerId="ADAL" clId="{F8B8F41D-B794-42A0-82BE-37996429007F}" dt="2024-05-16T09:19:18.461" v="1024" actId="255"/>
          <ac:spMkLst>
            <pc:docMk/>
            <pc:sldMk cId="79386092" sldId="259"/>
            <ac:spMk id="5" creationId="{C7DE899C-0D50-6ED7-E93C-5D7BD04B55D8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D45B9-175F-47FE-A36A-81F52BE0B07B}" type="datetimeFigureOut">
              <a:rPr lang="nb-NO" smtClean="0"/>
              <a:t>01.09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DC4D-1166-4069-96F6-EB53E8E85A9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7492276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D45B9-175F-47FE-A36A-81F52BE0B07B}" type="datetimeFigureOut">
              <a:rPr lang="nb-NO" smtClean="0"/>
              <a:t>01.09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DC4D-1166-4069-96F6-EB53E8E85A9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0807253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D45B9-175F-47FE-A36A-81F52BE0B07B}" type="datetimeFigureOut">
              <a:rPr lang="nb-NO" smtClean="0"/>
              <a:t>01.09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DC4D-1166-4069-96F6-EB53E8E85A9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9541253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D45B9-175F-47FE-A36A-81F52BE0B07B}" type="datetimeFigureOut">
              <a:rPr lang="nb-NO" smtClean="0"/>
              <a:t>01.09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DC4D-1166-4069-96F6-EB53E8E85A9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2118437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D45B9-175F-47FE-A36A-81F52BE0B07B}" type="datetimeFigureOut">
              <a:rPr lang="nb-NO" smtClean="0"/>
              <a:t>01.09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DC4D-1166-4069-96F6-EB53E8E85A9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8937917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D45B9-175F-47FE-A36A-81F52BE0B07B}" type="datetimeFigureOut">
              <a:rPr lang="nb-NO" smtClean="0"/>
              <a:t>01.09.2024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DC4D-1166-4069-96F6-EB53E8E85A9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021102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D45B9-175F-47FE-A36A-81F52BE0B07B}" type="datetimeFigureOut">
              <a:rPr lang="nb-NO" smtClean="0"/>
              <a:t>01.09.2024</a:t>
            </a:fld>
            <a:endParaRPr lang="nb-N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DC4D-1166-4069-96F6-EB53E8E85A9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762230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D45B9-175F-47FE-A36A-81F52BE0B07B}" type="datetimeFigureOut">
              <a:rPr lang="nb-NO" smtClean="0"/>
              <a:t>01.09.2024</a:t>
            </a:fld>
            <a:endParaRPr lang="nb-N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DC4D-1166-4069-96F6-EB53E8E85A9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0661636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D45B9-175F-47FE-A36A-81F52BE0B07B}" type="datetimeFigureOut">
              <a:rPr lang="nb-NO" smtClean="0"/>
              <a:t>01.09.2024</a:t>
            </a:fld>
            <a:endParaRPr lang="nb-N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DC4D-1166-4069-96F6-EB53E8E85A9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1320816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D45B9-175F-47FE-A36A-81F52BE0B07B}" type="datetimeFigureOut">
              <a:rPr lang="nb-NO" smtClean="0"/>
              <a:t>01.09.2024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DC4D-1166-4069-96F6-EB53E8E85A9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1561799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D45B9-175F-47FE-A36A-81F52BE0B07B}" type="datetimeFigureOut">
              <a:rPr lang="nb-NO" smtClean="0"/>
              <a:t>01.09.2024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DC4D-1166-4069-96F6-EB53E8E85A9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6149491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FD45B9-175F-47FE-A36A-81F52BE0B07B}" type="datetimeFigureOut">
              <a:rPr lang="nb-NO" smtClean="0"/>
              <a:t>01.09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0CDC4D-1166-4069-96F6-EB53E8E85A9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096619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7DE899C-0D50-6ED7-E93C-5D7BD04B55D8}"/>
              </a:ext>
            </a:extLst>
          </p:cNvPr>
          <p:cNvSpPr txBox="1"/>
          <p:nvPr/>
        </p:nvSpPr>
        <p:spPr>
          <a:xfrm>
            <a:off x="596900" y="825500"/>
            <a:ext cx="5816600" cy="44012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 smtClean="0"/>
              <a:t>Brain </a:t>
            </a:r>
            <a:r>
              <a:rPr lang="en-US" sz="1400" dirty="0"/>
              <a:t>abscess causes brain damage and long-lasting focal cerebral hypoactivity. </a:t>
            </a:r>
          </a:p>
          <a:p>
            <a:r>
              <a:rPr lang="en-US" sz="1400" dirty="0"/>
              <a:t>A cross-sectional </a:t>
            </a:r>
            <a:r>
              <a:rPr lang="en-US" sz="1400" baseline="30000" dirty="0"/>
              <a:t>18</a:t>
            </a:r>
            <a:r>
              <a:rPr lang="en-US" sz="1400" dirty="0"/>
              <a:t>F-fluoro-deoxyglucose positron emission tomography study.</a:t>
            </a:r>
            <a:endParaRPr lang="nb-NO" sz="1400" dirty="0"/>
          </a:p>
          <a:p>
            <a:r>
              <a:rPr lang="en-US" sz="1400" dirty="0"/>
              <a:t> </a:t>
            </a:r>
          </a:p>
          <a:p>
            <a:endParaRPr lang="en-US" sz="1400" dirty="0"/>
          </a:p>
          <a:p>
            <a:pPr algn="just"/>
            <a:r>
              <a:rPr lang="en-US" sz="1400" b="1" dirty="0"/>
              <a:t>Supplemental figure 1.</a:t>
            </a:r>
          </a:p>
          <a:p>
            <a:pPr algn="just"/>
            <a:endParaRPr lang="nb-NO" sz="1400" dirty="0"/>
          </a:p>
          <a:p>
            <a:pPr algn="just"/>
            <a:r>
              <a:rPr lang="nb-NO" sz="1400" dirty="0" err="1"/>
              <a:t>Flow</a:t>
            </a:r>
            <a:r>
              <a:rPr lang="nb-NO" sz="1400" dirty="0"/>
              <a:t> </a:t>
            </a:r>
            <a:r>
              <a:rPr lang="nb-NO" sz="1400" dirty="0" err="1"/>
              <a:t>chart</a:t>
            </a:r>
            <a:r>
              <a:rPr lang="nb-NO" sz="1400" dirty="0"/>
              <a:t> </a:t>
            </a:r>
            <a:r>
              <a:rPr lang="nb-NO" sz="1400" dirty="0" err="1"/>
              <a:t>of</a:t>
            </a:r>
            <a:r>
              <a:rPr lang="nb-NO" sz="1400" dirty="0"/>
              <a:t> </a:t>
            </a:r>
            <a:r>
              <a:rPr lang="nb-NO" sz="1400" dirty="0" err="1"/>
              <a:t>patient</a:t>
            </a:r>
            <a:r>
              <a:rPr lang="nb-NO" sz="1400" dirty="0"/>
              <a:t> </a:t>
            </a:r>
            <a:r>
              <a:rPr lang="nb-NO" sz="1400" dirty="0" err="1"/>
              <a:t>recruitment</a:t>
            </a:r>
            <a:r>
              <a:rPr lang="nb-NO" sz="1400" dirty="0"/>
              <a:t>.</a:t>
            </a:r>
          </a:p>
          <a:p>
            <a:pPr algn="just"/>
            <a:r>
              <a:rPr lang="nb-NO" sz="1400" dirty="0" err="1"/>
              <a:t>Fifty</a:t>
            </a:r>
            <a:r>
              <a:rPr lang="nb-NO" sz="1400" dirty="0"/>
              <a:t> </a:t>
            </a:r>
            <a:r>
              <a:rPr lang="nb-NO" sz="1400" dirty="0" err="1"/>
              <a:t>patients</a:t>
            </a:r>
            <a:r>
              <a:rPr lang="nb-NO" sz="1400" dirty="0"/>
              <a:t> </a:t>
            </a:r>
            <a:r>
              <a:rPr lang="nb-NO" sz="1400" dirty="0" err="1"/>
              <a:t>were</a:t>
            </a:r>
            <a:r>
              <a:rPr lang="nb-NO" sz="1400" dirty="0"/>
              <a:t> </a:t>
            </a:r>
            <a:r>
              <a:rPr lang="nb-NO" sz="1400" dirty="0" err="1"/>
              <a:t>invited</a:t>
            </a:r>
            <a:r>
              <a:rPr lang="nb-NO" sz="1400" dirty="0"/>
              <a:t> to </a:t>
            </a:r>
            <a:r>
              <a:rPr lang="nb-NO" sz="1400" dirty="0" err="1"/>
              <a:t>take</a:t>
            </a:r>
            <a:r>
              <a:rPr lang="nb-NO" sz="1400" dirty="0"/>
              <a:t> part in </a:t>
            </a:r>
            <a:r>
              <a:rPr lang="nb-NO" sz="1400" dirty="0" err="1"/>
              <a:t>the</a:t>
            </a:r>
            <a:r>
              <a:rPr lang="nb-NO" sz="1400" dirty="0"/>
              <a:t> </a:t>
            </a:r>
            <a:r>
              <a:rPr lang="nb-NO" sz="1400" dirty="0" err="1"/>
              <a:t>study</a:t>
            </a:r>
            <a:r>
              <a:rPr lang="nb-NO" sz="1400" dirty="0"/>
              <a:t>. Seven </a:t>
            </a:r>
            <a:r>
              <a:rPr lang="nb-NO" sz="1400" dirty="0" err="1"/>
              <a:t>declined</a:t>
            </a:r>
            <a:r>
              <a:rPr lang="nb-NO" sz="1400" dirty="0"/>
              <a:t> </a:t>
            </a:r>
            <a:r>
              <a:rPr lang="nb-NO" sz="1400" dirty="0" err="1"/>
              <a:t>the</a:t>
            </a:r>
            <a:r>
              <a:rPr lang="nb-NO" sz="1400" dirty="0"/>
              <a:t> </a:t>
            </a:r>
            <a:r>
              <a:rPr lang="nb-NO" sz="1400" dirty="0" err="1"/>
              <a:t>invitation</a:t>
            </a:r>
            <a:r>
              <a:rPr lang="nb-NO" sz="1400" dirty="0"/>
              <a:t>, </a:t>
            </a:r>
            <a:r>
              <a:rPr lang="nb-NO" sz="1400" dirty="0" err="1"/>
              <a:t>three</a:t>
            </a:r>
            <a:r>
              <a:rPr lang="nb-NO" sz="1400" dirty="0"/>
              <a:t> </a:t>
            </a:r>
            <a:r>
              <a:rPr lang="nb-NO" sz="1400" dirty="0" err="1"/>
              <a:t>were</a:t>
            </a:r>
            <a:r>
              <a:rPr lang="nb-NO" sz="1400" dirty="0"/>
              <a:t> </a:t>
            </a:r>
            <a:r>
              <a:rPr lang="nb-NO" sz="1400" dirty="0" err="1"/>
              <a:t>excluded</a:t>
            </a:r>
            <a:r>
              <a:rPr lang="nb-NO" sz="1400" dirty="0"/>
              <a:t> </a:t>
            </a:r>
            <a:r>
              <a:rPr lang="nb-NO" sz="1400" dirty="0" err="1"/>
              <a:t>because</a:t>
            </a:r>
            <a:r>
              <a:rPr lang="nb-NO" sz="1400" dirty="0"/>
              <a:t> </a:t>
            </a:r>
            <a:r>
              <a:rPr lang="nb-NO" sz="1400" dirty="0" err="1"/>
              <a:t>their</a:t>
            </a:r>
            <a:r>
              <a:rPr lang="nb-NO" sz="1400" dirty="0"/>
              <a:t> FDG-PET/CT </a:t>
            </a:r>
            <a:r>
              <a:rPr lang="nb-NO" sz="1400" dirty="0" err="1"/>
              <a:t>findings</a:t>
            </a:r>
            <a:r>
              <a:rPr lang="nb-NO" sz="1400" dirty="0"/>
              <a:t> </a:t>
            </a:r>
            <a:r>
              <a:rPr lang="nb-NO" sz="1400" dirty="0" err="1"/>
              <a:t>could</a:t>
            </a:r>
            <a:r>
              <a:rPr lang="nb-NO" sz="1400" dirty="0"/>
              <a:t> be </a:t>
            </a:r>
            <a:r>
              <a:rPr lang="nb-NO" sz="1400" dirty="0" err="1"/>
              <a:t>attributed</a:t>
            </a:r>
            <a:r>
              <a:rPr lang="nb-NO" sz="1400" dirty="0"/>
              <a:t> to </a:t>
            </a:r>
            <a:r>
              <a:rPr lang="nb-NO" sz="1400" dirty="0" err="1"/>
              <a:t>conditions</a:t>
            </a:r>
            <a:r>
              <a:rPr lang="nb-NO" sz="1400" dirty="0"/>
              <a:t> </a:t>
            </a:r>
            <a:r>
              <a:rPr lang="nb-NO" sz="1400" dirty="0" err="1"/>
              <a:t>other</a:t>
            </a:r>
            <a:r>
              <a:rPr lang="nb-NO" sz="1400" dirty="0"/>
              <a:t> </a:t>
            </a:r>
            <a:r>
              <a:rPr lang="nb-NO" sz="1400" dirty="0" err="1"/>
              <a:t>than</a:t>
            </a:r>
            <a:r>
              <a:rPr lang="nb-NO" sz="1400" dirty="0"/>
              <a:t> </a:t>
            </a:r>
            <a:r>
              <a:rPr lang="nb-NO" sz="1400" dirty="0" err="1"/>
              <a:t>brain</a:t>
            </a:r>
            <a:r>
              <a:rPr lang="nb-NO" sz="1400" dirty="0"/>
              <a:t> abscess: </a:t>
            </a:r>
            <a:r>
              <a:rPr lang="nb-NO" sz="1400" dirty="0" err="1"/>
              <a:t>meningioma</a:t>
            </a:r>
            <a:r>
              <a:rPr lang="nb-NO" sz="1400" dirty="0"/>
              <a:t> </a:t>
            </a:r>
            <a:r>
              <a:rPr lang="nb-NO" sz="1400" dirty="0" err="1"/>
              <a:t>surgery</a:t>
            </a:r>
            <a:r>
              <a:rPr lang="nb-NO" sz="1400" dirty="0"/>
              <a:t> (n=2) and </a:t>
            </a:r>
            <a:r>
              <a:rPr lang="nb-NO" sz="1400" dirty="0" err="1"/>
              <a:t>foreign</a:t>
            </a:r>
            <a:r>
              <a:rPr lang="nb-NO" sz="1400" dirty="0"/>
              <a:t> body (n=1). Thus 40 </a:t>
            </a:r>
            <a:r>
              <a:rPr lang="nb-NO" sz="1400" dirty="0" err="1"/>
              <a:t>patients</a:t>
            </a:r>
            <a:r>
              <a:rPr lang="nb-NO" sz="1400" dirty="0"/>
              <a:t> </a:t>
            </a:r>
            <a:r>
              <a:rPr lang="nb-NO" sz="1400" dirty="0" err="1"/>
              <a:t>took</a:t>
            </a:r>
            <a:r>
              <a:rPr lang="nb-NO" sz="1400" dirty="0"/>
              <a:t> part in </a:t>
            </a:r>
            <a:r>
              <a:rPr lang="nb-NO" sz="1400" dirty="0" err="1"/>
              <a:t>the</a:t>
            </a:r>
            <a:r>
              <a:rPr lang="nb-NO" sz="1400" dirty="0"/>
              <a:t> </a:t>
            </a:r>
            <a:r>
              <a:rPr lang="nb-NO" sz="1400" dirty="0" err="1" smtClean="0"/>
              <a:t>study</a:t>
            </a:r>
            <a:r>
              <a:rPr lang="nb-NO" sz="1400" dirty="0"/>
              <a:t> </a:t>
            </a:r>
            <a:r>
              <a:rPr lang="nb-NO" sz="1400" dirty="0" smtClean="0"/>
              <a:t>and </a:t>
            </a:r>
            <a:r>
              <a:rPr lang="nb-NO" sz="1400" dirty="0" err="1" smtClean="0"/>
              <a:t>underwent</a:t>
            </a:r>
            <a:r>
              <a:rPr lang="nb-NO" sz="1400" dirty="0" smtClean="0"/>
              <a:t> MRI and FDG-PET/CT. </a:t>
            </a:r>
            <a:r>
              <a:rPr lang="nb-NO" sz="1400" dirty="0" err="1" smtClean="0"/>
              <a:t>Findings</a:t>
            </a:r>
            <a:r>
              <a:rPr lang="nb-NO" sz="1400" dirty="0" smtClean="0"/>
              <a:t> in </a:t>
            </a:r>
            <a:r>
              <a:rPr lang="nb-NO" sz="1400" dirty="0" err="1" smtClean="0"/>
              <a:t>these</a:t>
            </a:r>
            <a:r>
              <a:rPr lang="nb-NO" sz="1400" dirty="0" smtClean="0"/>
              <a:t> 40 </a:t>
            </a:r>
            <a:r>
              <a:rPr lang="nb-NO" sz="1400" dirty="0" err="1" smtClean="0"/>
              <a:t>patients</a:t>
            </a:r>
            <a:r>
              <a:rPr lang="nb-NO" sz="1400" dirty="0" smtClean="0"/>
              <a:t> </a:t>
            </a:r>
            <a:r>
              <a:rPr lang="nb-NO" sz="1400" dirty="0" err="1" smtClean="0"/>
              <a:t>underlie</a:t>
            </a:r>
            <a:r>
              <a:rPr lang="nb-NO" sz="1400" dirty="0" smtClean="0"/>
              <a:t> </a:t>
            </a:r>
            <a:r>
              <a:rPr lang="nb-NO" sz="1400" dirty="0" err="1" smtClean="0"/>
              <a:t>the</a:t>
            </a:r>
            <a:r>
              <a:rPr lang="nb-NO" sz="1400" dirty="0" smtClean="0"/>
              <a:t> </a:t>
            </a:r>
            <a:r>
              <a:rPr lang="nb-NO" sz="1400" dirty="0" err="1" smtClean="0"/>
              <a:t>correlation</a:t>
            </a:r>
            <a:r>
              <a:rPr lang="nb-NO" sz="1400" dirty="0" smtClean="0"/>
              <a:t> </a:t>
            </a:r>
            <a:r>
              <a:rPr lang="nb-NO" sz="1400" dirty="0" err="1" smtClean="0"/>
              <a:t>between</a:t>
            </a:r>
            <a:r>
              <a:rPr lang="nb-NO" sz="1400" dirty="0" smtClean="0"/>
              <a:t> abscess </a:t>
            </a:r>
            <a:r>
              <a:rPr lang="nb-NO" sz="1400" dirty="0" err="1" smtClean="0"/>
              <a:t>dimension</a:t>
            </a:r>
            <a:r>
              <a:rPr lang="nb-NO" sz="1400" dirty="0" smtClean="0"/>
              <a:t> and </a:t>
            </a:r>
            <a:r>
              <a:rPr lang="nb-NO" sz="1400" dirty="0" err="1" smtClean="0"/>
              <a:t>extent</a:t>
            </a:r>
            <a:r>
              <a:rPr lang="nb-NO" sz="1400" dirty="0" smtClean="0"/>
              <a:t> </a:t>
            </a:r>
            <a:r>
              <a:rPr lang="nb-NO" sz="1400" dirty="0" err="1" smtClean="0"/>
              <a:t>of</a:t>
            </a:r>
            <a:r>
              <a:rPr lang="nb-NO" sz="1400" dirty="0" smtClean="0"/>
              <a:t> </a:t>
            </a:r>
            <a:r>
              <a:rPr lang="nb-NO" sz="1400" dirty="0" err="1" smtClean="0"/>
              <a:t>cortical</a:t>
            </a:r>
            <a:r>
              <a:rPr lang="nb-NO" sz="1400" dirty="0" smtClean="0"/>
              <a:t> </a:t>
            </a:r>
            <a:r>
              <a:rPr lang="nb-NO" sz="1400" dirty="0" err="1" smtClean="0"/>
              <a:t>hypometabolism</a:t>
            </a:r>
            <a:r>
              <a:rPr lang="nb-NO" sz="1400" dirty="0" smtClean="0"/>
              <a:t>.</a:t>
            </a:r>
            <a:endParaRPr lang="nb-NO" sz="1400" dirty="0"/>
          </a:p>
          <a:p>
            <a:pPr algn="just"/>
            <a:endParaRPr lang="nb-NO" sz="1400" dirty="0"/>
          </a:p>
          <a:p>
            <a:pPr algn="just"/>
            <a:r>
              <a:rPr lang="nb-NO" sz="1400" dirty="0"/>
              <a:t>For </a:t>
            </a:r>
            <a:r>
              <a:rPr lang="nb-NO" sz="1400" dirty="0" err="1"/>
              <a:t>nine</a:t>
            </a:r>
            <a:r>
              <a:rPr lang="nb-NO" sz="1400" dirty="0"/>
              <a:t> </a:t>
            </a:r>
            <a:r>
              <a:rPr lang="nb-NO" sz="1400" dirty="0" err="1"/>
              <a:t>patients</a:t>
            </a:r>
            <a:r>
              <a:rPr lang="nb-NO" sz="1400" dirty="0"/>
              <a:t>, </a:t>
            </a:r>
            <a:r>
              <a:rPr lang="nb-NO" sz="1400" dirty="0" err="1"/>
              <a:t>follow</a:t>
            </a:r>
            <a:r>
              <a:rPr lang="nb-NO" sz="1400" dirty="0"/>
              <a:t>-up MRIs </a:t>
            </a:r>
            <a:r>
              <a:rPr lang="nb-NO" sz="1400" dirty="0" err="1"/>
              <a:t>performed</a:t>
            </a:r>
            <a:r>
              <a:rPr lang="nb-NO" sz="1400" dirty="0"/>
              <a:t> </a:t>
            </a:r>
            <a:r>
              <a:rPr lang="nb-NO" sz="1400" dirty="0">
                <a:sym typeface="Symbol" panose="05050102010706020507" pitchFamily="18" charset="2"/>
              </a:rPr>
              <a:t> 1 </a:t>
            </a:r>
            <a:r>
              <a:rPr lang="nb-NO" sz="1400" dirty="0" err="1">
                <a:sym typeface="Symbol" panose="05050102010706020507" pitchFamily="18" charset="2"/>
              </a:rPr>
              <a:t>year</a:t>
            </a:r>
            <a:r>
              <a:rPr lang="nb-NO" sz="1400" dirty="0">
                <a:sym typeface="Symbol" panose="05050102010706020507" pitchFamily="18" charset="2"/>
              </a:rPr>
              <a:t> </a:t>
            </a:r>
            <a:r>
              <a:rPr lang="nb-NO" sz="1400" dirty="0" err="1">
                <a:sym typeface="Symbol" panose="05050102010706020507" pitchFamily="18" charset="2"/>
              </a:rPr>
              <a:t>after</a:t>
            </a:r>
            <a:r>
              <a:rPr lang="nb-NO" sz="1400" dirty="0">
                <a:sym typeface="Symbol" panose="05050102010706020507" pitchFamily="18" charset="2"/>
              </a:rPr>
              <a:t> </a:t>
            </a:r>
          </a:p>
          <a:p>
            <a:pPr algn="just"/>
            <a:r>
              <a:rPr lang="nb-NO" sz="1400" dirty="0" err="1">
                <a:sym typeface="Symbol" panose="05050102010706020507" pitchFamily="18" charset="2"/>
              </a:rPr>
              <a:t>brain</a:t>
            </a:r>
            <a:r>
              <a:rPr lang="nb-NO" sz="1400" dirty="0">
                <a:sym typeface="Symbol" panose="05050102010706020507" pitchFamily="18" charset="2"/>
              </a:rPr>
              <a:t> abscess </a:t>
            </a:r>
            <a:r>
              <a:rPr lang="nb-NO" sz="1400" dirty="0" err="1">
                <a:sym typeface="Symbol" panose="05050102010706020507" pitchFamily="18" charset="2"/>
              </a:rPr>
              <a:t>surgery</a:t>
            </a:r>
            <a:r>
              <a:rPr lang="nb-NO" sz="1400" dirty="0">
                <a:sym typeface="Symbol" panose="05050102010706020507" pitchFamily="18" charset="2"/>
              </a:rPr>
              <a:t> </a:t>
            </a:r>
            <a:r>
              <a:rPr lang="nb-NO" sz="1400" dirty="0" err="1">
                <a:sym typeface="Symbol" panose="05050102010706020507" pitchFamily="18" charset="2"/>
              </a:rPr>
              <a:t>were</a:t>
            </a:r>
            <a:r>
              <a:rPr lang="nb-NO" sz="1400" dirty="0">
                <a:sym typeface="Symbol" panose="05050102010706020507" pitchFamily="18" charset="2"/>
              </a:rPr>
              <a:t> </a:t>
            </a:r>
            <a:r>
              <a:rPr lang="nb-NO" sz="1400" dirty="0" err="1" smtClean="0">
                <a:sym typeface="Symbol" panose="05050102010706020507" pitchFamily="18" charset="2"/>
              </a:rPr>
              <a:t>available</a:t>
            </a:r>
            <a:r>
              <a:rPr lang="nb-NO" sz="1400" dirty="0" smtClean="0">
                <a:sym typeface="Symbol" panose="05050102010706020507" pitchFamily="18" charset="2"/>
              </a:rPr>
              <a:t> for </a:t>
            </a:r>
            <a:r>
              <a:rPr lang="nb-NO" sz="1400" dirty="0" err="1" smtClean="0">
                <a:sym typeface="Symbol" panose="05050102010706020507" pitchFamily="18" charset="2"/>
              </a:rPr>
              <a:t>evaluation</a:t>
            </a:r>
            <a:r>
              <a:rPr lang="nb-NO" sz="1400" dirty="0" smtClean="0">
                <a:sym typeface="Symbol" panose="05050102010706020507" pitchFamily="18" charset="2"/>
              </a:rPr>
              <a:t> </a:t>
            </a:r>
            <a:r>
              <a:rPr lang="nb-NO" sz="1400" dirty="0" err="1" smtClean="0">
                <a:sym typeface="Symbol" panose="05050102010706020507" pitchFamily="18" charset="2"/>
              </a:rPr>
              <a:t>of</a:t>
            </a:r>
            <a:r>
              <a:rPr lang="nb-NO" sz="1400" dirty="0" smtClean="0">
                <a:sym typeface="Symbol" panose="05050102010706020507" pitchFamily="18" charset="2"/>
              </a:rPr>
              <a:t> long-term </a:t>
            </a:r>
            <a:r>
              <a:rPr lang="nb-NO" sz="1400" dirty="0" err="1" smtClean="0">
                <a:sym typeface="Symbol" panose="05050102010706020507" pitchFamily="18" charset="2"/>
              </a:rPr>
              <a:t>structural</a:t>
            </a:r>
            <a:r>
              <a:rPr lang="nb-NO" sz="1400" dirty="0" smtClean="0">
                <a:sym typeface="Symbol" panose="05050102010706020507" pitchFamily="18" charset="2"/>
              </a:rPr>
              <a:t> </a:t>
            </a:r>
            <a:r>
              <a:rPr lang="nb-NO" sz="1400" dirty="0" err="1" smtClean="0">
                <a:sym typeface="Symbol" panose="05050102010706020507" pitchFamily="18" charset="2"/>
              </a:rPr>
              <a:t>effects</a:t>
            </a:r>
            <a:r>
              <a:rPr lang="nb-NO" sz="1400" dirty="0" smtClean="0">
                <a:sym typeface="Symbol" panose="05050102010706020507" pitchFamily="18" charset="2"/>
              </a:rPr>
              <a:t> </a:t>
            </a:r>
            <a:r>
              <a:rPr lang="nb-NO" sz="1400" dirty="0" err="1" smtClean="0">
                <a:sym typeface="Symbol" panose="05050102010706020507" pitchFamily="18" charset="2"/>
              </a:rPr>
              <a:t>of</a:t>
            </a:r>
            <a:r>
              <a:rPr lang="nb-NO" sz="1400" dirty="0" smtClean="0">
                <a:sym typeface="Symbol" panose="05050102010706020507" pitchFamily="18" charset="2"/>
              </a:rPr>
              <a:t> </a:t>
            </a:r>
            <a:r>
              <a:rPr lang="nb-NO" sz="1400" dirty="0" err="1" smtClean="0">
                <a:sym typeface="Symbol" panose="05050102010706020507" pitchFamily="18" charset="2"/>
              </a:rPr>
              <a:t>brain</a:t>
            </a:r>
            <a:r>
              <a:rPr lang="nb-NO" sz="1400" dirty="0" smtClean="0">
                <a:sym typeface="Symbol" panose="05050102010706020507" pitchFamily="18" charset="2"/>
              </a:rPr>
              <a:t> </a:t>
            </a:r>
            <a:r>
              <a:rPr lang="nb-NO" sz="1400" dirty="0" err="1" smtClean="0">
                <a:sym typeface="Symbol" panose="05050102010706020507" pitchFamily="18" charset="2"/>
              </a:rPr>
              <a:t>abscesses</a:t>
            </a:r>
            <a:r>
              <a:rPr lang="nb-NO" sz="1400" dirty="0" smtClean="0">
                <a:sym typeface="Symbol" panose="05050102010706020507" pitchFamily="18" charset="2"/>
              </a:rPr>
              <a:t>.</a:t>
            </a:r>
            <a:endParaRPr lang="nb-NO" sz="1400" dirty="0"/>
          </a:p>
        </p:txBody>
      </p:sp>
    </p:spTree>
    <p:extLst>
      <p:ext uri="{BB962C8B-B14F-4D97-AF65-F5344CB8AC3E}">
        <p14:creationId xmlns:p14="http://schemas.microsoft.com/office/powerpoint/2010/main" val="793860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1" name="Group 70">
            <a:extLst>
              <a:ext uri="{FF2B5EF4-FFF2-40B4-BE49-F238E27FC236}">
                <a16:creationId xmlns:a16="http://schemas.microsoft.com/office/drawing/2014/main" id="{579080F4-7AE4-F69F-8B39-FF30017F7168}"/>
              </a:ext>
            </a:extLst>
          </p:cNvPr>
          <p:cNvGrpSpPr/>
          <p:nvPr/>
        </p:nvGrpSpPr>
        <p:grpSpPr>
          <a:xfrm>
            <a:off x="971981" y="546100"/>
            <a:ext cx="5417276" cy="8851563"/>
            <a:chOff x="971981" y="546100"/>
            <a:chExt cx="5417276" cy="8851563"/>
          </a:xfrm>
        </p:grpSpPr>
        <p:grpSp>
          <p:nvGrpSpPr>
            <p:cNvPr id="70" name="Group 69">
              <a:extLst>
                <a:ext uri="{FF2B5EF4-FFF2-40B4-BE49-F238E27FC236}">
                  <a16:creationId xmlns:a16="http://schemas.microsoft.com/office/drawing/2014/main" id="{81AB49FF-5494-B30E-B10F-EEC7BBBEF9F5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971981" y="546100"/>
              <a:ext cx="2735881" cy="2492612"/>
              <a:chOff x="1871867" y="3950732"/>
              <a:chExt cx="4198393" cy="3825080"/>
            </a:xfrm>
          </p:grpSpPr>
          <p:grpSp>
            <p:nvGrpSpPr>
              <p:cNvPr id="15" name="Group 14">
                <a:extLst>
                  <a:ext uri="{FF2B5EF4-FFF2-40B4-BE49-F238E27FC236}">
                    <a16:creationId xmlns:a16="http://schemas.microsoft.com/office/drawing/2014/main" id="{444390F2-4910-D481-3655-6286B2DB6971}"/>
                  </a:ext>
                </a:extLst>
              </p:cNvPr>
              <p:cNvGrpSpPr/>
              <p:nvPr/>
            </p:nvGrpSpPr>
            <p:grpSpPr>
              <a:xfrm>
                <a:off x="2918309" y="4814332"/>
                <a:ext cx="1945451" cy="1932780"/>
                <a:chOff x="5026509" y="2782332"/>
                <a:chExt cx="1945451" cy="1932780"/>
              </a:xfrm>
            </p:grpSpPr>
            <p:pic>
              <p:nvPicPr>
                <p:cNvPr id="16" name="Bilde 1">
                  <a:extLst>
                    <a:ext uri="{FF2B5EF4-FFF2-40B4-BE49-F238E27FC236}">
                      <a16:creationId xmlns:a16="http://schemas.microsoft.com/office/drawing/2014/main" id="{A163DE9F-7CFD-BC1E-F4CE-FBE1B07E672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026509" y="27823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17" name="Bilde 1">
                  <a:extLst>
                    <a:ext uri="{FF2B5EF4-FFF2-40B4-BE49-F238E27FC236}">
                      <a16:creationId xmlns:a16="http://schemas.microsoft.com/office/drawing/2014/main" id="{8A755FC9-8AEA-7CB5-795D-BFEEAD44A30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178909" y="29347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18" name="Bilde 1">
                  <a:extLst>
                    <a:ext uri="{FF2B5EF4-FFF2-40B4-BE49-F238E27FC236}">
                      <a16:creationId xmlns:a16="http://schemas.microsoft.com/office/drawing/2014/main" id="{6546E309-E353-6889-45E4-FD4074206C6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331309" y="30871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19" name="Bilde 1">
                  <a:extLst>
                    <a:ext uri="{FF2B5EF4-FFF2-40B4-BE49-F238E27FC236}">
                      <a16:creationId xmlns:a16="http://schemas.microsoft.com/office/drawing/2014/main" id="{B7626880-CB58-3DFA-26A7-AFD116FA8CC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483709" y="32395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20" name="Bilde 1">
                  <a:extLst>
                    <a:ext uri="{FF2B5EF4-FFF2-40B4-BE49-F238E27FC236}">
                      <a16:creationId xmlns:a16="http://schemas.microsoft.com/office/drawing/2014/main" id="{42F76A2E-1600-BB3A-7B88-CD306F3C7BF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636109" y="33919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21" name="Bilde 1">
                  <a:extLst>
                    <a:ext uri="{FF2B5EF4-FFF2-40B4-BE49-F238E27FC236}">
                      <a16:creationId xmlns:a16="http://schemas.microsoft.com/office/drawing/2014/main" id="{2C3B54D1-F81F-0539-67C2-A634033588C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788509" y="35443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22" name="Bilde 1">
                  <a:extLst>
                    <a:ext uri="{FF2B5EF4-FFF2-40B4-BE49-F238E27FC236}">
                      <a16:creationId xmlns:a16="http://schemas.microsoft.com/office/drawing/2014/main" id="{4160A3CC-3F9A-08DC-41B8-0D41F714C9A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940909" y="36967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23" name="Bilde 1">
                  <a:extLst>
                    <a:ext uri="{FF2B5EF4-FFF2-40B4-BE49-F238E27FC236}">
                      <a16:creationId xmlns:a16="http://schemas.microsoft.com/office/drawing/2014/main" id="{2D216639-0434-DA19-F6B4-4512A7E260F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6093309" y="38491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24" name="Bilde 1">
                  <a:extLst>
                    <a:ext uri="{FF2B5EF4-FFF2-40B4-BE49-F238E27FC236}">
                      <a16:creationId xmlns:a16="http://schemas.microsoft.com/office/drawing/2014/main" id="{333E3041-5E32-918D-7C71-D11513E4D93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6245709" y="40015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25" name="Bilde 1">
                  <a:extLst>
                    <a:ext uri="{FF2B5EF4-FFF2-40B4-BE49-F238E27FC236}">
                      <a16:creationId xmlns:a16="http://schemas.microsoft.com/office/drawing/2014/main" id="{C20E25D5-DDA5-3C77-6E27-956B1E6A536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6398109" y="4153932"/>
                  <a:ext cx="573851" cy="561180"/>
                </a:xfrm>
                <a:prstGeom prst="rect">
                  <a:avLst/>
                </a:prstGeom>
              </p:spPr>
            </p:pic>
          </p:grpSp>
          <p:grpSp>
            <p:nvGrpSpPr>
              <p:cNvPr id="26" name="Group 25">
                <a:extLst>
                  <a:ext uri="{FF2B5EF4-FFF2-40B4-BE49-F238E27FC236}">
                    <a16:creationId xmlns:a16="http://schemas.microsoft.com/office/drawing/2014/main" id="{514805E3-F452-851E-D004-D0E9839A7430}"/>
                  </a:ext>
                </a:extLst>
              </p:cNvPr>
              <p:cNvGrpSpPr/>
              <p:nvPr/>
            </p:nvGrpSpPr>
            <p:grpSpPr>
              <a:xfrm>
                <a:off x="1871867" y="5843032"/>
                <a:ext cx="1945451" cy="1932780"/>
                <a:chOff x="5026509" y="2782332"/>
                <a:chExt cx="1945451" cy="1932780"/>
              </a:xfrm>
            </p:grpSpPr>
            <p:pic>
              <p:nvPicPr>
                <p:cNvPr id="27" name="Bilde 1">
                  <a:extLst>
                    <a:ext uri="{FF2B5EF4-FFF2-40B4-BE49-F238E27FC236}">
                      <a16:creationId xmlns:a16="http://schemas.microsoft.com/office/drawing/2014/main" id="{087E2465-3364-55F4-10FD-955455E2B12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026509" y="27823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28" name="Bilde 1">
                  <a:extLst>
                    <a:ext uri="{FF2B5EF4-FFF2-40B4-BE49-F238E27FC236}">
                      <a16:creationId xmlns:a16="http://schemas.microsoft.com/office/drawing/2014/main" id="{91A19C66-721E-9640-AE2B-ABC9B927558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178909" y="29347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29" name="Bilde 1">
                  <a:extLst>
                    <a:ext uri="{FF2B5EF4-FFF2-40B4-BE49-F238E27FC236}">
                      <a16:creationId xmlns:a16="http://schemas.microsoft.com/office/drawing/2014/main" id="{434899F8-2C3F-DA51-1C0E-246467ECA57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331309" y="30871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30" name="Bilde 1">
                  <a:extLst>
                    <a:ext uri="{FF2B5EF4-FFF2-40B4-BE49-F238E27FC236}">
                      <a16:creationId xmlns:a16="http://schemas.microsoft.com/office/drawing/2014/main" id="{AB138291-031F-8FC1-62FF-8C4B0890CBC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483709" y="32395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31" name="Bilde 1">
                  <a:extLst>
                    <a:ext uri="{FF2B5EF4-FFF2-40B4-BE49-F238E27FC236}">
                      <a16:creationId xmlns:a16="http://schemas.microsoft.com/office/drawing/2014/main" id="{C84F85E6-0E92-DE38-8750-3AAECA77781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636109" y="33919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32" name="Bilde 1">
                  <a:extLst>
                    <a:ext uri="{FF2B5EF4-FFF2-40B4-BE49-F238E27FC236}">
                      <a16:creationId xmlns:a16="http://schemas.microsoft.com/office/drawing/2014/main" id="{36869252-2A07-49D9-8A14-DB5223088C9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788509" y="35443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33" name="Bilde 1">
                  <a:extLst>
                    <a:ext uri="{FF2B5EF4-FFF2-40B4-BE49-F238E27FC236}">
                      <a16:creationId xmlns:a16="http://schemas.microsoft.com/office/drawing/2014/main" id="{B2514737-8786-D17C-A7AA-8540A18892B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940909" y="36967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34" name="Bilde 1">
                  <a:extLst>
                    <a:ext uri="{FF2B5EF4-FFF2-40B4-BE49-F238E27FC236}">
                      <a16:creationId xmlns:a16="http://schemas.microsoft.com/office/drawing/2014/main" id="{AAA69DB0-DE2D-8AC5-77E9-32B876A2FA5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6093309" y="38491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35" name="Bilde 1">
                  <a:extLst>
                    <a:ext uri="{FF2B5EF4-FFF2-40B4-BE49-F238E27FC236}">
                      <a16:creationId xmlns:a16="http://schemas.microsoft.com/office/drawing/2014/main" id="{4B1693E6-023F-75C2-8D80-295E61271F5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6245709" y="40015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36" name="Bilde 1">
                  <a:extLst>
                    <a:ext uri="{FF2B5EF4-FFF2-40B4-BE49-F238E27FC236}">
                      <a16:creationId xmlns:a16="http://schemas.microsoft.com/office/drawing/2014/main" id="{AEE56C3A-AE0A-C9E1-2203-B132FFD3894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6398109" y="4153932"/>
                  <a:ext cx="573851" cy="561180"/>
                </a:xfrm>
                <a:prstGeom prst="rect">
                  <a:avLst/>
                </a:prstGeom>
              </p:spPr>
            </p:pic>
          </p:grpSp>
          <p:grpSp>
            <p:nvGrpSpPr>
              <p:cNvPr id="37" name="Group 36">
                <a:extLst>
                  <a:ext uri="{FF2B5EF4-FFF2-40B4-BE49-F238E27FC236}">
                    <a16:creationId xmlns:a16="http://schemas.microsoft.com/office/drawing/2014/main" id="{12455A17-81EA-01A2-B5A7-279432389D93}"/>
                  </a:ext>
                </a:extLst>
              </p:cNvPr>
              <p:cNvGrpSpPr/>
              <p:nvPr/>
            </p:nvGrpSpPr>
            <p:grpSpPr>
              <a:xfrm>
                <a:off x="2308709" y="5246132"/>
                <a:ext cx="1945451" cy="1932780"/>
                <a:chOff x="5026509" y="2782332"/>
                <a:chExt cx="1945451" cy="1932780"/>
              </a:xfrm>
            </p:grpSpPr>
            <p:pic>
              <p:nvPicPr>
                <p:cNvPr id="38" name="Bilde 1">
                  <a:extLst>
                    <a:ext uri="{FF2B5EF4-FFF2-40B4-BE49-F238E27FC236}">
                      <a16:creationId xmlns:a16="http://schemas.microsoft.com/office/drawing/2014/main" id="{9C88A4B4-4DC4-59CF-0063-ED8D82B9D63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026509" y="27823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39" name="Bilde 1">
                  <a:extLst>
                    <a:ext uri="{FF2B5EF4-FFF2-40B4-BE49-F238E27FC236}">
                      <a16:creationId xmlns:a16="http://schemas.microsoft.com/office/drawing/2014/main" id="{D0DE6853-E96D-8E14-1F13-E9E27EA02FB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178909" y="29347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40" name="Bilde 1">
                  <a:extLst>
                    <a:ext uri="{FF2B5EF4-FFF2-40B4-BE49-F238E27FC236}">
                      <a16:creationId xmlns:a16="http://schemas.microsoft.com/office/drawing/2014/main" id="{142063C4-C845-F484-42B6-2A3ADA37F8F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331309" y="30871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41" name="Bilde 1">
                  <a:extLst>
                    <a:ext uri="{FF2B5EF4-FFF2-40B4-BE49-F238E27FC236}">
                      <a16:creationId xmlns:a16="http://schemas.microsoft.com/office/drawing/2014/main" id="{DD1246BA-CCA4-62B6-2FF6-B93546C3940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483709" y="32395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42" name="Bilde 1">
                  <a:extLst>
                    <a:ext uri="{FF2B5EF4-FFF2-40B4-BE49-F238E27FC236}">
                      <a16:creationId xmlns:a16="http://schemas.microsoft.com/office/drawing/2014/main" id="{6D829F06-1F9F-1A31-309D-4952ED1348D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636109" y="33919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43" name="Bilde 1">
                  <a:extLst>
                    <a:ext uri="{FF2B5EF4-FFF2-40B4-BE49-F238E27FC236}">
                      <a16:creationId xmlns:a16="http://schemas.microsoft.com/office/drawing/2014/main" id="{DDEE484A-5977-B93B-2EA1-E5790BE1004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788509" y="35443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44" name="Bilde 1">
                  <a:extLst>
                    <a:ext uri="{FF2B5EF4-FFF2-40B4-BE49-F238E27FC236}">
                      <a16:creationId xmlns:a16="http://schemas.microsoft.com/office/drawing/2014/main" id="{78FFCA89-2A0B-680F-6C94-F6ECB4E6C8B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940909" y="36967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45" name="Bilde 1">
                  <a:extLst>
                    <a:ext uri="{FF2B5EF4-FFF2-40B4-BE49-F238E27FC236}">
                      <a16:creationId xmlns:a16="http://schemas.microsoft.com/office/drawing/2014/main" id="{4BD3364B-7E93-A4FE-09F8-C664F71785B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6093309" y="38491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46" name="Bilde 1">
                  <a:extLst>
                    <a:ext uri="{FF2B5EF4-FFF2-40B4-BE49-F238E27FC236}">
                      <a16:creationId xmlns:a16="http://schemas.microsoft.com/office/drawing/2014/main" id="{A9023196-C5CF-0634-53B8-7F886733641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6245709" y="40015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47" name="Bilde 1">
                  <a:extLst>
                    <a:ext uri="{FF2B5EF4-FFF2-40B4-BE49-F238E27FC236}">
                      <a16:creationId xmlns:a16="http://schemas.microsoft.com/office/drawing/2014/main" id="{E953BF0A-4A22-9EC4-D7F9-817937A19D0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6398109" y="4153932"/>
                  <a:ext cx="573851" cy="561180"/>
                </a:xfrm>
                <a:prstGeom prst="rect">
                  <a:avLst/>
                </a:prstGeom>
              </p:spPr>
            </p:pic>
          </p:grpSp>
          <p:grpSp>
            <p:nvGrpSpPr>
              <p:cNvPr id="48" name="Group 47">
                <a:extLst>
                  <a:ext uri="{FF2B5EF4-FFF2-40B4-BE49-F238E27FC236}">
                    <a16:creationId xmlns:a16="http://schemas.microsoft.com/office/drawing/2014/main" id="{7E69553E-1E52-C160-ADCC-1C5FC8050F0F}"/>
                  </a:ext>
                </a:extLst>
              </p:cNvPr>
              <p:cNvGrpSpPr/>
              <p:nvPr/>
            </p:nvGrpSpPr>
            <p:grpSpPr>
              <a:xfrm>
                <a:off x="3527909" y="4382532"/>
                <a:ext cx="1945451" cy="1932780"/>
                <a:chOff x="5026509" y="2782332"/>
                <a:chExt cx="1945451" cy="1932780"/>
              </a:xfrm>
            </p:grpSpPr>
            <p:pic>
              <p:nvPicPr>
                <p:cNvPr id="49" name="Bilde 1">
                  <a:extLst>
                    <a:ext uri="{FF2B5EF4-FFF2-40B4-BE49-F238E27FC236}">
                      <a16:creationId xmlns:a16="http://schemas.microsoft.com/office/drawing/2014/main" id="{B5130E10-80AD-2256-001C-9B518A05BCE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026509" y="27823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50" name="Bilde 1">
                  <a:extLst>
                    <a:ext uri="{FF2B5EF4-FFF2-40B4-BE49-F238E27FC236}">
                      <a16:creationId xmlns:a16="http://schemas.microsoft.com/office/drawing/2014/main" id="{9F176444-92CD-DD52-80A0-FB89FF6DE0F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178909" y="29347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51" name="Bilde 1">
                  <a:extLst>
                    <a:ext uri="{FF2B5EF4-FFF2-40B4-BE49-F238E27FC236}">
                      <a16:creationId xmlns:a16="http://schemas.microsoft.com/office/drawing/2014/main" id="{B492CFEA-55AD-D1A6-6EB0-CAEE819BAE5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331309" y="30871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52" name="Bilde 1">
                  <a:extLst>
                    <a:ext uri="{FF2B5EF4-FFF2-40B4-BE49-F238E27FC236}">
                      <a16:creationId xmlns:a16="http://schemas.microsoft.com/office/drawing/2014/main" id="{C3ADCD7D-C996-1445-53B8-DE73E8623A2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483709" y="32395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53" name="Bilde 1">
                  <a:extLst>
                    <a:ext uri="{FF2B5EF4-FFF2-40B4-BE49-F238E27FC236}">
                      <a16:creationId xmlns:a16="http://schemas.microsoft.com/office/drawing/2014/main" id="{46167485-E848-5D84-BF67-E00EC228292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636109" y="33919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54" name="Bilde 1">
                  <a:extLst>
                    <a:ext uri="{FF2B5EF4-FFF2-40B4-BE49-F238E27FC236}">
                      <a16:creationId xmlns:a16="http://schemas.microsoft.com/office/drawing/2014/main" id="{70769440-4D81-7A59-496A-53472D054A0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788509" y="35443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55" name="Bilde 1">
                  <a:extLst>
                    <a:ext uri="{FF2B5EF4-FFF2-40B4-BE49-F238E27FC236}">
                      <a16:creationId xmlns:a16="http://schemas.microsoft.com/office/drawing/2014/main" id="{2477C30F-8C7A-852D-7B77-679D83619A8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940909" y="36967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56" name="Bilde 1">
                  <a:extLst>
                    <a:ext uri="{FF2B5EF4-FFF2-40B4-BE49-F238E27FC236}">
                      <a16:creationId xmlns:a16="http://schemas.microsoft.com/office/drawing/2014/main" id="{D59AAE9A-C597-F348-F29C-78BF32F14C8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6093309" y="38491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57" name="Bilde 1">
                  <a:extLst>
                    <a:ext uri="{FF2B5EF4-FFF2-40B4-BE49-F238E27FC236}">
                      <a16:creationId xmlns:a16="http://schemas.microsoft.com/office/drawing/2014/main" id="{CBF6B1DF-09D8-EC92-A374-BDCB56AD5C1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6245709" y="40015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58" name="Bilde 1">
                  <a:extLst>
                    <a:ext uri="{FF2B5EF4-FFF2-40B4-BE49-F238E27FC236}">
                      <a16:creationId xmlns:a16="http://schemas.microsoft.com/office/drawing/2014/main" id="{1CC52812-9A12-3181-CDD0-FF78089F856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6398109" y="4153932"/>
                  <a:ext cx="573851" cy="561180"/>
                </a:xfrm>
                <a:prstGeom prst="rect">
                  <a:avLst/>
                </a:prstGeom>
              </p:spPr>
            </p:pic>
          </p:grpSp>
          <p:grpSp>
            <p:nvGrpSpPr>
              <p:cNvPr id="59" name="Group 58">
                <a:extLst>
                  <a:ext uri="{FF2B5EF4-FFF2-40B4-BE49-F238E27FC236}">
                    <a16:creationId xmlns:a16="http://schemas.microsoft.com/office/drawing/2014/main" id="{18611903-FD2A-F454-B4CA-DB07F0DC386F}"/>
                  </a:ext>
                </a:extLst>
              </p:cNvPr>
              <p:cNvGrpSpPr/>
              <p:nvPr/>
            </p:nvGrpSpPr>
            <p:grpSpPr>
              <a:xfrm>
                <a:off x="4124809" y="3950732"/>
                <a:ext cx="1945451" cy="1932780"/>
                <a:chOff x="5026509" y="2782332"/>
                <a:chExt cx="1945451" cy="1932780"/>
              </a:xfrm>
            </p:grpSpPr>
            <p:pic>
              <p:nvPicPr>
                <p:cNvPr id="60" name="Bilde 1">
                  <a:extLst>
                    <a:ext uri="{FF2B5EF4-FFF2-40B4-BE49-F238E27FC236}">
                      <a16:creationId xmlns:a16="http://schemas.microsoft.com/office/drawing/2014/main" id="{FCF5966D-285D-56DC-5C3F-5F9EADAD8AD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026509" y="27823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61" name="Bilde 1">
                  <a:extLst>
                    <a:ext uri="{FF2B5EF4-FFF2-40B4-BE49-F238E27FC236}">
                      <a16:creationId xmlns:a16="http://schemas.microsoft.com/office/drawing/2014/main" id="{37E1C14E-7DA2-85F6-F80F-AE7D4106C2F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178909" y="29347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62" name="Bilde 1">
                  <a:extLst>
                    <a:ext uri="{FF2B5EF4-FFF2-40B4-BE49-F238E27FC236}">
                      <a16:creationId xmlns:a16="http://schemas.microsoft.com/office/drawing/2014/main" id="{BDC14649-755C-9C03-1761-A1337FD2A0F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331309" y="30871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63" name="Bilde 1">
                  <a:extLst>
                    <a:ext uri="{FF2B5EF4-FFF2-40B4-BE49-F238E27FC236}">
                      <a16:creationId xmlns:a16="http://schemas.microsoft.com/office/drawing/2014/main" id="{EFFE22F4-226E-3BF2-76C6-15D23D4B752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483709" y="32395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64" name="Bilde 1">
                  <a:extLst>
                    <a:ext uri="{FF2B5EF4-FFF2-40B4-BE49-F238E27FC236}">
                      <a16:creationId xmlns:a16="http://schemas.microsoft.com/office/drawing/2014/main" id="{7967E989-4AF3-117C-24F1-0BC3C5EDDE1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636109" y="33919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65" name="Bilde 1">
                  <a:extLst>
                    <a:ext uri="{FF2B5EF4-FFF2-40B4-BE49-F238E27FC236}">
                      <a16:creationId xmlns:a16="http://schemas.microsoft.com/office/drawing/2014/main" id="{B6592BA9-D965-5AF6-C680-B5A54ABD0E2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788509" y="35443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66" name="Bilde 1">
                  <a:extLst>
                    <a:ext uri="{FF2B5EF4-FFF2-40B4-BE49-F238E27FC236}">
                      <a16:creationId xmlns:a16="http://schemas.microsoft.com/office/drawing/2014/main" id="{BE2D633C-A7E2-6E7F-4C4A-2BE809311A3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940909" y="36967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67" name="Bilde 1">
                  <a:extLst>
                    <a:ext uri="{FF2B5EF4-FFF2-40B4-BE49-F238E27FC236}">
                      <a16:creationId xmlns:a16="http://schemas.microsoft.com/office/drawing/2014/main" id="{B1FE7CCB-A55D-3868-B188-9DAAF323EE1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6093309" y="38491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68" name="Bilde 1">
                  <a:extLst>
                    <a:ext uri="{FF2B5EF4-FFF2-40B4-BE49-F238E27FC236}">
                      <a16:creationId xmlns:a16="http://schemas.microsoft.com/office/drawing/2014/main" id="{4009B5F8-7269-7723-8D28-DA7847337B9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6245709" y="4001532"/>
                  <a:ext cx="573851" cy="561180"/>
                </a:xfrm>
                <a:prstGeom prst="rect">
                  <a:avLst/>
                </a:prstGeom>
              </p:spPr>
            </p:pic>
            <p:pic>
              <p:nvPicPr>
                <p:cNvPr id="69" name="Bilde 1">
                  <a:extLst>
                    <a:ext uri="{FF2B5EF4-FFF2-40B4-BE49-F238E27FC236}">
                      <a16:creationId xmlns:a16="http://schemas.microsoft.com/office/drawing/2014/main" id="{644E073A-BEC9-07F7-3C67-91BB2F18AC8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6398109" y="4153932"/>
                  <a:ext cx="573851" cy="561180"/>
                </a:xfrm>
                <a:prstGeom prst="rect">
                  <a:avLst/>
                </a:prstGeom>
              </p:spPr>
            </p:pic>
          </p:grpSp>
        </p:grpSp>
        <p:grpSp>
          <p:nvGrpSpPr>
            <p:cNvPr id="128" name="Group 127">
              <a:extLst>
                <a:ext uri="{FF2B5EF4-FFF2-40B4-BE49-F238E27FC236}">
                  <a16:creationId xmlns:a16="http://schemas.microsoft.com/office/drawing/2014/main" id="{2BB1FF02-8A38-57E2-3C5C-C2E88E9BE864}"/>
                </a:ext>
              </a:extLst>
            </p:cNvPr>
            <p:cNvGrpSpPr/>
            <p:nvPr/>
          </p:nvGrpSpPr>
          <p:grpSpPr>
            <a:xfrm>
              <a:off x="1653894" y="5312565"/>
              <a:ext cx="1267752" cy="1259495"/>
              <a:chOff x="5026509" y="2782332"/>
              <a:chExt cx="1945451" cy="1932780"/>
            </a:xfrm>
          </p:grpSpPr>
          <p:pic>
            <p:nvPicPr>
              <p:cNvPr id="173" name="Bilde 1">
                <a:extLst>
                  <a:ext uri="{FF2B5EF4-FFF2-40B4-BE49-F238E27FC236}">
                    <a16:creationId xmlns:a16="http://schemas.microsoft.com/office/drawing/2014/main" id="{550F2D9C-9031-699F-53F9-C751DCE2AC0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026509" y="27823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74" name="Bilde 1">
                <a:extLst>
                  <a:ext uri="{FF2B5EF4-FFF2-40B4-BE49-F238E27FC236}">
                    <a16:creationId xmlns:a16="http://schemas.microsoft.com/office/drawing/2014/main" id="{B0A8ACC6-6D14-B81B-975F-C23F65A698C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178909" y="29347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75" name="Bilde 1">
                <a:extLst>
                  <a:ext uri="{FF2B5EF4-FFF2-40B4-BE49-F238E27FC236}">
                    <a16:creationId xmlns:a16="http://schemas.microsoft.com/office/drawing/2014/main" id="{240C6D28-04E4-A910-BB1F-729542D9681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331309" y="30871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76" name="Bilde 1">
                <a:extLst>
                  <a:ext uri="{FF2B5EF4-FFF2-40B4-BE49-F238E27FC236}">
                    <a16:creationId xmlns:a16="http://schemas.microsoft.com/office/drawing/2014/main" id="{87DAEE29-B0D7-93E4-BFB4-DD3F10AA285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483709" y="32395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77" name="Bilde 1">
                <a:extLst>
                  <a:ext uri="{FF2B5EF4-FFF2-40B4-BE49-F238E27FC236}">
                    <a16:creationId xmlns:a16="http://schemas.microsoft.com/office/drawing/2014/main" id="{DA58F981-A653-FBD9-FBD3-F0C7FEC58E0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636109" y="33919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78" name="Bilde 1">
                <a:extLst>
                  <a:ext uri="{FF2B5EF4-FFF2-40B4-BE49-F238E27FC236}">
                    <a16:creationId xmlns:a16="http://schemas.microsoft.com/office/drawing/2014/main" id="{F5FC8B16-FE5F-FF34-3826-BEF96EA1347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788509" y="35443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79" name="Bilde 1">
                <a:extLst>
                  <a:ext uri="{FF2B5EF4-FFF2-40B4-BE49-F238E27FC236}">
                    <a16:creationId xmlns:a16="http://schemas.microsoft.com/office/drawing/2014/main" id="{32F2C18E-DCAA-4CD5-02EA-1DB4781B3E1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940909" y="36967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80" name="Bilde 1">
                <a:extLst>
                  <a:ext uri="{FF2B5EF4-FFF2-40B4-BE49-F238E27FC236}">
                    <a16:creationId xmlns:a16="http://schemas.microsoft.com/office/drawing/2014/main" id="{82386E32-12CD-E2A4-B95B-5F5A53E8076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093309" y="38491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81" name="Bilde 1">
                <a:extLst>
                  <a:ext uri="{FF2B5EF4-FFF2-40B4-BE49-F238E27FC236}">
                    <a16:creationId xmlns:a16="http://schemas.microsoft.com/office/drawing/2014/main" id="{26AF968D-5947-743D-B4C7-BE58F9E3A47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245709" y="40015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82" name="Bilde 1">
                <a:extLst>
                  <a:ext uri="{FF2B5EF4-FFF2-40B4-BE49-F238E27FC236}">
                    <a16:creationId xmlns:a16="http://schemas.microsoft.com/office/drawing/2014/main" id="{CB4E8DBB-6A84-B0E6-5812-0C7590A8393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398109" y="4153932"/>
                <a:ext cx="573851" cy="561180"/>
              </a:xfrm>
              <a:prstGeom prst="rect">
                <a:avLst/>
              </a:prstGeom>
            </p:spPr>
          </p:pic>
        </p:grpSp>
        <p:grpSp>
          <p:nvGrpSpPr>
            <p:cNvPr id="129" name="Group 128">
              <a:extLst>
                <a:ext uri="{FF2B5EF4-FFF2-40B4-BE49-F238E27FC236}">
                  <a16:creationId xmlns:a16="http://schemas.microsoft.com/office/drawing/2014/main" id="{721AD9BD-6E30-2A9F-7F14-B9029B8415CF}"/>
                </a:ext>
              </a:extLst>
            </p:cNvPr>
            <p:cNvGrpSpPr/>
            <p:nvPr/>
          </p:nvGrpSpPr>
          <p:grpSpPr>
            <a:xfrm>
              <a:off x="971981" y="5982917"/>
              <a:ext cx="1267752" cy="1259495"/>
              <a:chOff x="5026509" y="2782332"/>
              <a:chExt cx="1945451" cy="1932780"/>
            </a:xfrm>
          </p:grpSpPr>
          <p:pic>
            <p:nvPicPr>
              <p:cNvPr id="163" name="Bilde 1">
                <a:extLst>
                  <a:ext uri="{FF2B5EF4-FFF2-40B4-BE49-F238E27FC236}">
                    <a16:creationId xmlns:a16="http://schemas.microsoft.com/office/drawing/2014/main" id="{A02EC1CB-3370-BCA4-D482-0206D6DA8BA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026509" y="27823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64" name="Bilde 1">
                <a:extLst>
                  <a:ext uri="{FF2B5EF4-FFF2-40B4-BE49-F238E27FC236}">
                    <a16:creationId xmlns:a16="http://schemas.microsoft.com/office/drawing/2014/main" id="{46B96C5F-51B6-644C-02B7-4014F814888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178909" y="29347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65" name="Bilde 1">
                <a:extLst>
                  <a:ext uri="{FF2B5EF4-FFF2-40B4-BE49-F238E27FC236}">
                    <a16:creationId xmlns:a16="http://schemas.microsoft.com/office/drawing/2014/main" id="{2790A332-3918-F5FD-474E-83A44B679D7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331309" y="30871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66" name="Bilde 1">
                <a:extLst>
                  <a:ext uri="{FF2B5EF4-FFF2-40B4-BE49-F238E27FC236}">
                    <a16:creationId xmlns:a16="http://schemas.microsoft.com/office/drawing/2014/main" id="{44AC9439-7CB0-9331-3F3C-F7B6E587AD8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483709" y="32395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67" name="Bilde 1">
                <a:extLst>
                  <a:ext uri="{FF2B5EF4-FFF2-40B4-BE49-F238E27FC236}">
                    <a16:creationId xmlns:a16="http://schemas.microsoft.com/office/drawing/2014/main" id="{BC07C037-1059-0E1E-C733-26D2E692AA7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636109" y="33919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68" name="Bilde 1">
                <a:extLst>
                  <a:ext uri="{FF2B5EF4-FFF2-40B4-BE49-F238E27FC236}">
                    <a16:creationId xmlns:a16="http://schemas.microsoft.com/office/drawing/2014/main" id="{5B0AD627-D61F-9737-D1D9-2ABAA6EF929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788509" y="35443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69" name="Bilde 1">
                <a:extLst>
                  <a:ext uri="{FF2B5EF4-FFF2-40B4-BE49-F238E27FC236}">
                    <a16:creationId xmlns:a16="http://schemas.microsoft.com/office/drawing/2014/main" id="{B2E00300-8D77-F98B-4897-DCA9C41E1E6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940909" y="36967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70" name="Bilde 1">
                <a:extLst>
                  <a:ext uri="{FF2B5EF4-FFF2-40B4-BE49-F238E27FC236}">
                    <a16:creationId xmlns:a16="http://schemas.microsoft.com/office/drawing/2014/main" id="{6877EF22-4885-1F57-A604-6DFDF6259F9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093309" y="38491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71" name="Bilde 1">
                <a:extLst>
                  <a:ext uri="{FF2B5EF4-FFF2-40B4-BE49-F238E27FC236}">
                    <a16:creationId xmlns:a16="http://schemas.microsoft.com/office/drawing/2014/main" id="{DB9DCEAC-F3E0-9CE8-379E-2C969591F00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245709" y="40015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72" name="Bilde 1">
                <a:extLst>
                  <a:ext uri="{FF2B5EF4-FFF2-40B4-BE49-F238E27FC236}">
                    <a16:creationId xmlns:a16="http://schemas.microsoft.com/office/drawing/2014/main" id="{5CAB864D-E5D6-8F48-03C8-83CE0629518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398109" y="4153932"/>
                <a:ext cx="573851" cy="561180"/>
              </a:xfrm>
              <a:prstGeom prst="rect">
                <a:avLst/>
              </a:prstGeom>
            </p:spPr>
          </p:pic>
        </p:grpSp>
        <p:grpSp>
          <p:nvGrpSpPr>
            <p:cNvPr id="130" name="Group 129">
              <a:extLst>
                <a:ext uri="{FF2B5EF4-FFF2-40B4-BE49-F238E27FC236}">
                  <a16:creationId xmlns:a16="http://schemas.microsoft.com/office/drawing/2014/main" id="{90840B97-B2C1-E7FD-7FFE-81A4F67EE9F4}"/>
                </a:ext>
              </a:extLst>
            </p:cNvPr>
            <p:cNvGrpSpPr/>
            <p:nvPr/>
          </p:nvGrpSpPr>
          <p:grpSpPr>
            <a:xfrm>
              <a:off x="1256649" y="5593947"/>
              <a:ext cx="1267752" cy="1259495"/>
              <a:chOff x="5026509" y="2782332"/>
              <a:chExt cx="1945451" cy="1932780"/>
            </a:xfrm>
          </p:grpSpPr>
          <p:pic>
            <p:nvPicPr>
              <p:cNvPr id="153" name="Bilde 1">
                <a:extLst>
                  <a:ext uri="{FF2B5EF4-FFF2-40B4-BE49-F238E27FC236}">
                    <a16:creationId xmlns:a16="http://schemas.microsoft.com/office/drawing/2014/main" id="{A30924A5-9FCB-1DED-6AC8-D5B94F3F881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026509" y="27823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54" name="Bilde 1">
                <a:extLst>
                  <a:ext uri="{FF2B5EF4-FFF2-40B4-BE49-F238E27FC236}">
                    <a16:creationId xmlns:a16="http://schemas.microsoft.com/office/drawing/2014/main" id="{3CA2AE86-01E2-87AD-2FBD-40CBD65E442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178909" y="29347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55" name="Bilde 1">
                <a:extLst>
                  <a:ext uri="{FF2B5EF4-FFF2-40B4-BE49-F238E27FC236}">
                    <a16:creationId xmlns:a16="http://schemas.microsoft.com/office/drawing/2014/main" id="{EBB08C13-2797-6CE7-0711-9E5BA434F6C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331309" y="30871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56" name="Bilde 1">
                <a:extLst>
                  <a:ext uri="{FF2B5EF4-FFF2-40B4-BE49-F238E27FC236}">
                    <a16:creationId xmlns:a16="http://schemas.microsoft.com/office/drawing/2014/main" id="{8CBEFE35-2972-FE35-E882-6A28C2CE0A9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483709" y="32395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57" name="Bilde 1">
                <a:extLst>
                  <a:ext uri="{FF2B5EF4-FFF2-40B4-BE49-F238E27FC236}">
                    <a16:creationId xmlns:a16="http://schemas.microsoft.com/office/drawing/2014/main" id="{FB6AD8A2-D145-3E3E-71A3-48FB5CF1372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636109" y="33919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58" name="Bilde 1">
                <a:extLst>
                  <a:ext uri="{FF2B5EF4-FFF2-40B4-BE49-F238E27FC236}">
                    <a16:creationId xmlns:a16="http://schemas.microsoft.com/office/drawing/2014/main" id="{DB72BC2F-FD64-6978-D778-E94AA44E892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788509" y="35443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59" name="Bilde 1">
                <a:extLst>
                  <a:ext uri="{FF2B5EF4-FFF2-40B4-BE49-F238E27FC236}">
                    <a16:creationId xmlns:a16="http://schemas.microsoft.com/office/drawing/2014/main" id="{7783C85E-39F7-6E37-D977-B1A8953A639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940909" y="36967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60" name="Bilde 1">
                <a:extLst>
                  <a:ext uri="{FF2B5EF4-FFF2-40B4-BE49-F238E27FC236}">
                    <a16:creationId xmlns:a16="http://schemas.microsoft.com/office/drawing/2014/main" id="{871E7BD6-D455-5791-7EB1-22BC4A948C7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093309" y="38491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61" name="Bilde 1">
                <a:extLst>
                  <a:ext uri="{FF2B5EF4-FFF2-40B4-BE49-F238E27FC236}">
                    <a16:creationId xmlns:a16="http://schemas.microsoft.com/office/drawing/2014/main" id="{84C345E5-F10D-838C-2FF3-179198D4CC7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245709" y="40015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62" name="Bilde 1">
                <a:extLst>
                  <a:ext uri="{FF2B5EF4-FFF2-40B4-BE49-F238E27FC236}">
                    <a16:creationId xmlns:a16="http://schemas.microsoft.com/office/drawing/2014/main" id="{6AB7014F-8BEB-560B-99F7-F601BCF1E6C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398109" y="4153932"/>
                <a:ext cx="573851" cy="561180"/>
              </a:xfrm>
              <a:prstGeom prst="rect">
                <a:avLst/>
              </a:prstGeom>
            </p:spPr>
          </p:pic>
        </p:grpSp>
        <p:grpSp>
          <p:nvGrpSpPr>
            <p:cNvPr id="131" name="Group 130">
              <a:extLst>
                <a:ext uri="{FF2B5EF4-FFF2-40B4-BE49-F238E27FC236}">
                  <a16:creationId xmlns:a16="http://schemas.microsoft.com/office/drawing/2014/main" id="{2BA21C9E-A51A-6782-953B-B00E9E91111F}"/>
                </a:ext>
              </a:extLst>
            </p:cNvPr>
            <p:cNvGrpSpPr/>
            <p:nvPr/>
          </p:nvGrpSpPr>
          <p:grpSpPr>
            <a:xfrm>
              <a:off x="2051140" y="5031182"/>
              <a:ext cx="1267752" cy="1259495"/>
              <a:chOff x="5026509" y="2782332"/>
              <a:chExt cx="1945451" cy="1932780"/>
            </a:xfrm>
          </p:grpSpPr>
          <p:pic>
            <p:nvPicPr>
              <p:cNvPr id="143" name="Bilde 1">
                <a:extLst>
                  <a:ext uri="{FF2B5EF4-FFF2-40B4-BE49-F238E27FC236}">
                    <a16:creationId xmlns:a16="http://schemas.microsoft.com/office/drawing/2014/main" id="{1A77D600-1384-710F-7AA7-C3218DBB542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026509" y="27823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44" name="Bilde 1">
                <a:extLst>
                  <a:ext uri="{FF2B5EF4-FFF2-40B4-BE49-F238E27FC236}">
                    <a16:creationId xmlns:a16="http://schemas.microsoft.com/office/drawing/2014/main" id="{3A977B48-E552-22C8-71EC-814FACE6083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178909" y="29347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45" name="Bilde 1">
                <a:extLst>
                  <a:ext uri="{FF2B5EF4-FFF2-40B4-BE49-F238E27FC236}">
                    <a16:creationId xmlns:a16="http://schemas.microsoft.com/office/drawing/2014/main" id="{4AACC1D1-73B4-1202-F4E5-238AA417C5A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331309" y="30871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46" name="Bilde 1">
                <a:extLst>
                  <a:ext uri="{FF2B5EF4-FFF2-40B4-BE49-F238E27FC236}">
                    <a16:creationId xmlns:a16="http://schemas.microsoft.com/office/drawing/2014/main" id="{9AA7E9D5-4F0C-68F7-8333-0D7E0099EE9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483709" y="32395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47" name="Bilde 1">
                <a:extLst>
                  <a:ext uri="{FF2B5EF4-FFF2-40B4-BE49-F238E27FC236}">
                    <a16:creationId xmlns:a16="http://schemas.microsoft.com/office/drawing/2014/main" id="{C87E4BBC-EEF6-95E1-C3E3-2449EADAC6E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636109" y="33919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48" name="Bilde 1">
                <a:extLst>
                  <a:ext uri="{FF2B5EF4-FFF2-40B4-BE49-F238E27FC236}">
                    <a16:creationId xmlns:a16="http://schemas.microsoft.com/office/drawing/2014/main" id="{1FA9E6CC-BB70-A214-F412-EF71B376E5E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788509" y="35443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49" name="Bilde 1">
                <a:extLst>
                  <a:ext uri="{FF2B5EF4-FFF2-40B4-BE49-F238E27FC236}">
                    <a16:creationId xmlns:a16="http://schemas.microsoft.com/office/drawing/2014/main" id="{C030E2F2-351D-752E-5297-7F9AAD99708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940909" y="36967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50" name="Bilde 1">
                <a:extLst>
                  <a:ext uri="{FF2B5EF4-FFF2-40B4-BE49-F238E27FC236}">
                    <a16:creationId xmlns:a16="http://schemas.microsoft.com/office/drawing/2014/main" id="{DF21906F-DA18-9707-2069-42F6C605480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093309" y="38491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51" name="Bilde 1">
                <a:extLst>
                  <a:ext uri="{FF2B5EF4-FFF2-40B4-BE49-F238E27FC236}">
                    <a16:creationId xmlns:a16="http://schemas.microsoft.com/office/drawing/2014/main" id="{A3822368-8BE3-2DC7-168E-4062B5E7016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245709" y="40015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52" name="Bilde 1">
                <a:extLst>
                  <a:ext uri="{FF2B5EF4-FFF2-40B4-BE49-F238E27FC236}">
                    <a16:creationId xmlns:a16="http://schemas.microsoft.com/office/drawing/2014/main" id="{01D1F4E6-5D9C-F6A0-344F-1AFE689EF93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398109" y="4153932"/>
                <a:ext cx="573851" cy="561180"/>
              </a:xfrm>
              <a:prstGeom prst="rect">
                <a:avLst/>
              </a:prstGeom>
            </p:spPr>
          </p:pic>
        </p:grpSp>
        <p:grpSp>
          <p:nvGrpSpPr>
            <p:cNvPr id="186" name="Group 185">
              <a:extLst>
                <a:ext uri="{FF2B5EF4-FFF2-40B4-BE49-F238E27FC236}">
                  <a16:creationId xmlns:a16="http://schemas.microsoft.com/office/drawing/2014/main" id="{1065B2BB-E415-7DD8-067F-16EB435EAFEE}"/>
                </a:ext>
              </a:extLst>
            </p:cNvPr>
            <p:cNvGrpSpPr/>
            <p:nvPr/>
          </p:nvGrpSpPr>
          <p:grpSpPr>
            <a:xfrm>
              <a:off x="3271617" y="2699798"/>
              <a:ext cx="970745" cy="961561"/>
              <a:chOff x="1384370" y="3546558"/>
              <a:chExt cx="970745" cy="961561"/>
            </a:xfrm>
          </p:grpSpPr>
          <p:grpSp>
            <p:nvGrpSpPr>
              <p:cNvPr id="185" name="Group 184">
                <a:extLst>
                  <a:ext uri="{FF2B5EF4-FFF2-40B4-BE49-F238E27FC236}">
                    <a16:creationId xmlns:a16="http://schemas.microsoft.com/office/drawing/2014/main" id="{369DFDEE-78AD-D03B-F53D-E40A9A1836E1}"/>
                  </a:ext>
                </a:extLst>
              </p:cNvPr>
              <p:cNvGrpSpPr/>
              <p:nvPr/>
            </p:nvGrpSpPr>
            <p:grpSpPr>
              <a:xfrm>
                <a:off x="1384370" y="3546558"/>
                <a:ext cx="970745" cy="961561"/>
                <a:chOff x="1384370" y="3546558"/>
                <a:chExt cx="970745" cy="961561"/>
              </a:xfrm>
            </p:grpSpPr>
            <p:pic>
              <p:nvPicPr>
                <p:cNvPr id="133" name="Bilde 1">
                  <a:extLst>
                    <a:ext uri="{FF2B5EF4-FFF2-40B4-BE49-F238E27FC236}">
                      <a16:creationId xmlns:a16="http://schemas.microsoft.com/office/drawing/2014/main" id="{F1F0144E-8B3F-35C9-CB5E-8EB10B71688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384370" y="3546558"/>
                  <a:ext cx="373950" cy="365693"/>
                </a:xfrm>
                <a:prstGeom prst="rect">
                  <a:avLst/>
                </a:prstGeom>
              </p:spPr>
            </p:pic>
            <p:pic>
              <p:nvPicPr>
                <p:cNvPr id="134" name="Bilde 1">
                  <a:extLst>
                    <a:ext uri="{FF2B5EF4-FFF2-40B4-BE49-F238E27FC236}">
                      <a16:creationId xmlns:a16="http://schemas.microsoft.com/office/drawing/2014/main" id="{C64563AC-836B-E7CC-8074-46C53E18CAC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483681" y="3645869"/>
                  <a:ext cx="373950" cy="365693"/>
                </a:xfrm>
                <a:prstGeom prst="rect">
                  <a:avLst/>
                </a:prstGeom>
              </p:spPr>
            </p:pic>
            <p:pic>
              <p:nvPicPr>
                <p:cNvPr id="136" name="Bilde 1">
                  <a:extLst>
                    <a:ext uri="{FF2B5EF4-FFF2-40B4-BE49-F238E27FC236}">
                      <a16:creationId xmlns:a16="http://schemas.microsoft.com/office/drawing/2014/main" id="{20BD61E9-EB30-A144-75BD-06CFDDDEFEB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682304" y="3844492"/>
                  <a:ext cx="373950" cy="365693"/>
                </a:xfrm>
                <a:prstGeom prst="rect">
                  <a:avLst/>
                </a:prstGeom>
              </p:spPr>
            </p:pic>
            <p:pic>
              <p:nvPicPr>
                <p:cNvPr id="137" name="Bilde 1">
                  <a:extLst>
                    <a:ext uri="{FF2B5EF4-FFF2-40B4-BE49-F238E27FC236}">
                      <a16:creationId xmlns:a16="http://schemas.microsoft.com/office/drawing/2014/main" id="{6901F162-7E46-506D-813E-2F8341B6D26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781615" y="3943803"/>
                  <a:ext cx="373950" cy="365693"/>
                </a:xfrm>
                <a:prstGeom prst="rect">
                  <a:avLst/>
                </a:prstGeom>
              </p:spPr>
            </p:pic>
            <p:pic>
              <p:nvPicPr>
                <p:cNvPr id="138" name="Bilde 1">
                  <a:extLst>
                    <a:ext uri="{FF2B5EF4-FFF2-40B4-BE49-F238E27FC236}">
                      <a16:creationId xmlns:a16="http://schemas.microsoft.com/office/drawing/2014/main" id="{53A75A5B-EC63-4107-36EB-42C5C182B65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880926" y="4043115"/>
                  <a:ext cx="373950" cy="365693"/>
                </a:xfrm>
                <a:prstGeom prst="rect">
                  <a:avLst/>
                </a:prstGeom>
              </p:spPr>
            </p:pic>
            <p:pic>
              <p:nvPicPr>
                <p:cNvPr id="139" name="Bilde 1">
                  <a:extLst>
                    <a:ext uri="{FF2B5EF4-FFF2-40B4-BE49-F238E27FC236}">
                      <a16:creationId xmlns:a16="http://schemas.microsoft.com/office/drawing/2014/main" id="{CA5D28CC-3098-15D7-5C66-BAE1F58119E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981165" y="4142426"/>
                  <a:ext cx="373950" cy="365693"/>
                </a:xfrm>
                <a:prstGeom prst="rect">
                  <a:avLst/>
                </a:prstGeom>
              </p:spPr>
            </p:pic>
          </p:grpSp>
          <p:pic>
            <p:nvPicPr>
              <p:cNvPr id="135" name="Bilde 1">
                <a:extLst>
                  <a:ext uri="{FF2B5EF4-FFF2-40B4-BE49-F238E27FC236}">
                    <a16:creationId xmlns:a16="http://schemas.microsoft.com/office/drawing/2014/main" id="{BE8868F1-7D99-D5D6-456C-9199F8A5D36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583920" y="3745181"/>
                <a:ext cx="373950" cy="365693"/>
              </a:xfrm>
              <a:prstGeom prst="rect">
                <a:avLst/>
              </a:prstGeom>
            </p:spPr>
          </p:pic>
        </p:grpSp>
        <p:grpSp>
          <p:nvGrpSpPr>
            <p:cNvPr id="184" name="Group 183">
              <a:extLst>
                <a:ext uri="{FF2B5EF4-FFF2-40B4-BE49-F238E27FC236}">
                  <a16:creationId xmlns:a16="http://schemas.microsoft.com/office/drawing/2014/main" id="{AD719264-367E-CE7F-8F19-41A9E1C4FBEA}"/>
                </a:ext>
              </a:extLst>
            </p:cNvPr>
            <p:cNvGrpSpPr/>
            <p:nvPr/>
          </p:nvGrpSpPr>
          <p:grpSpPr>
            <a:xfrm>
              <a:off x="3310616" y="4257383"/>
              <a:ext cx="572571" cy="564315"/>
              <a:chOff x="1229577" y="5321238"/>
              <a:chExt cx="572571" cy="564315"/>
            </a:xfrm>
          </p:grpSpPr>
          <p:pic>
            <p:nvPicPr>
              <p:cNvPr id="140" name="Bilde 1">
                <a:extLst>
                  <a:ext uri="{FF2B5EF4-FFF2-40B4-BE49-F238E27FC236}">
                    <a16:creationId xmlns:a16="http://schemas.microsoft.com/office/drawing/2014/main" id="{18B16C1A-AD4D-E24D-FDB4-278C6C674F3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229577" y="5321238"/>
                <a:ext cx="373950" cy="365693"/>
              </a:xfrm>
              <a:prstGeom prst="rect">
                <a:avLst/>
              </a:prstGeom>
            </p:spPr>
          </p:pic>
          <p:pic>
            <p:nvPicPr>
              <p:cNvPr id="141" name="Bilde 1">
                <a:extLst>
                  <a:ext uri="{FF2B5EF4-FFF2-40B4-BE49-F238E27FC236}">
                    <a16:creationId xmlns:a16="http://schemas.microsoft.com/office/drawing/2014/main" id="{58AFB398-E034-5945-3CF8-44AAA28A8DD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328888" y="5420549"/>
                <a:ext cx="373950" cy="365693"/>
              </a:xfrm>
              <a:prstGeom prst="rect">
                <a:avLst/>
              </a:prstGeom>
            </p:spPr>
          </p:pic>
          <p:pic>
            <p:nvPicPr>
              <p:cNvPr id="142" name="Bilde 1">
                <a:extLst>
                  <a:ext uri="{FF2B5EF4-FFF2-40B4-BE49-F238E27FC236}">
                    <a16:creationId xmlns:a16="http://schemas.microsoft.com/office/drawing/2014/main" id="{444B4324-DCA2-17C9-762B-9D06314507C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428198" y="5519860"/>
                <a:ext cx="373950" cy="365693"/>
              </a:xfrm>
              <a:prstGeom prst="rect">
                <a:avLst/>
              </a:prstGeom>
            </p:spPr>
          </p:pic>
        </p:grpSp>
        <p:sp>
          <p:nvSpPr>
            <p:cNvPr id="187" name="TextBox 186">
              <a:extLst>
                <a:ext uri="{FF2B5EF4-FFF2-40B4-BE49-F238E27FC236}">
                  <a16:creationId xmlns:a16="http://schemas.microsoft.com/office/drawing/2014/main" id="{CA9D7660-580A-3942-8A21-6243390E6211}"/>
                </a:ext>
              </a:extLst>
            </p:cNvPr>
            <p:cNvSpPr txBox="1"/>
            <p:nvPr/>
          </p:nvSpPr>
          <p:spPr>
            <a:xfrm>
              <a:off x="3074852" y="2127587"/>
              <a:ext cx="21717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50 patients invited</a:t>
              </a:r>
              <a:endParaRPr lang="nb-NO" sz="1600" dirty="0"/>
            </a:p>
          </p:txBody>
        </p:sp>
        <p:sp>
          <p:nvSpPr>
            <p:cNvPr id="188" name="TextBox 187">
              <a:extLst>
                <a:ext uri="{FF2B5EF4-FFF2-40B4-BE49-F238E27FC236}">
                  <a16:creationId xmlns:a16="http://schemas.microsoft.com/office/drawing/2014/main" id="{ACE894E3-5C19-3AA8-68B0-6326931140F7}"/>
                </a:ext>
              </a:extLst>
            </p:cNvPr>
            <p:cNvSpPr txBox="1"/>
            <p:nvPr/>
          </p:nvSpPr>
          <p:spPr>
            <a:xfrm>
              <a:off x="3056272" y="3609738"/>
              <a:ext cx="333298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7 patients declined the invitation</a:t>
              </a:r>
              <a:endParaRPr lang="nb-NO" sz="1200" dirty="0"/>
            </a:p>
          </p:txBody>
        </p:sp>
        <p:sp>
          <p:nvSpPr>
            <p:cNvPr id="189" name="TextBox 188">
              <a:extLst>
                <a:ext uri="{FF2B5EF4-FFF2-40B4-BE49-F238E27FC236}">
                  <a16:creationId xmlns:a16="http://schemas.microsoft.com/office/drawing/2014/main" id="{AB426C21-C4A8-564C-26E6-93A7DA327E04}"/>
                </a:ext>
              </a:extLst>
            </p:cNvPr>
            <p:cNvSpPr txBox="1"/>
            <p:nvPr/>
          </p:nvSpPr>
          <p:spPr>
            <a:xfrm>
              <a:off x="3092779" y="4867593"/>
              <a:ext cx="329647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3 patients excluded: abscess after </a:t>
              </a:r>
            </a:p>
            <a:p>
              <a:r>
                <a:rPr lang="en-US" sz="1200" dirty="0"/>
                <a:t>meningioma surgery (n=2) or</a:t>
              </a:r>
            </a:p>
            <a:p>
              <a:r>
                <a:rPr lang="en-US" sz="1200" dirty="0"/>
                <a:t>intracerebral foreign body (n=1)</a:t>
              </a:r>
              <a:endParaRPr lang="nb-NO" sz="1200" dirty="0"/>
            </a:p>
          </p:txBody>
        </p:sp>
        <p:sp>
          <p:nvSpPr>
            <p:cNvPr id="190" name="TextBox 189">
              <a:extLst>
                <a:ext uri="{FF2B5EF4-FFF2-40B4-BE49-F238E27FC236}">
                  <a16:creationId xmlns:a16="http://schemas.microsoft.com/office/drawing/2014/main" id="{E0E967FF-E3E1-4A81-5B43-4AEE950AAB06}"/>
                </a:ext>
              </a:extLst>
            </p:cNvPr>
            <p:cNvSpPr txBox="1"/>
            <p:nvPr/>
          </p:nvSpPr>
          <p:spPr>
            <a:xfrm>
              <a:off x="3077937" y="6426200"/>
              <a:ext cx="2510147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40 patients </a:t>
              </a:r>
              <a:r>
                <a:rPr lang="en-US" sz="1200" dirty="0" smtClean="0"/>
                <a:t>were included for MRI and FDG-PET/CT, which allowed the comparison of abscess dimension and extent of brain </a:t>
              </a:r>
              <a:r>
                <a:rPr lang="en-US" sz="1200" dirty="0" err="1" smtClean="0"/>
                <a:t>hypometabolism</a:t>
              </a:r>
              <a:r>
                <a:rPr lang="en-US" sz="1200" dirty="0" smtClean="0"/>
                <a:t>.</a:t>
              </a:r>
              <a:endParaRPr lang="nb-NO" sz="1200" dirty="0"/>
            </a:p>
          </p:txBody>
        </p:sp>
        <p:grpSp>
          <p:nvGrpSpPr>
            <p:cNvPr id="196" name="Group 195">
              <a:extLst>
                <a:ext uri="{FF2B5EF4-FFF2-40B4-BE49-F238E27FC236}">
                  <a16:creationId xmlns:a16="http://schemas.microsoft.com/office/drawing/2014/main" id="{E7351227-6AEA-B688-F84A-BFFD8C82FCB3}"/>
                </a:ext>
              </a:extLst>
            </p:cNvPr>
            <p:cNvGrpSpPr/>
            <p:nvPr/>
          </p:nvGrpSpPr>
          <p:grpSpPr>
            <a:xfrm>
              <a:off x="2913371" y="2538025"/>
              <a:ext cx="624285" cy="2592468"/>
              <a:chOff x="2390857" y="2538025"/>
              <a:chExt cx="624285" cy="2592468"/>
            </a:xfrm>
          </p:grpSpPr>
          <p:grpSp>
            <p:nvGrpSpPr>
              <p:cNvPr id="195" name="Group 194">
                <a:extLst>
                  <a:ext uri="{FF2B5EF4-FFF2-40B4-BE49-F238E27FC236}">
                    <a16:creationId xmlns:a16="http://schemas.microsoft.com/office/drawing/2014/main" id="{95B61168-FC2A-7911-72C3-0624BE757951}"/>
                  </a:ext>
                </a:extLst>
              </p:cNvPr>
              <p:cNvGrpSpPr/>
              <p:nvPr/>
            </p:nvGrpSpPr>
            <p:grpSpPr>
              <a:xfrm>
                <a:off x="2390857" y="2538025"/>
                <a:ext cx="612311" cy="2592468"/>
                <a:chOff x="2390857" y="2538025"/>
                <a:chExt cx="612311" cy="2592468"/>
              </a:xfrm>
            </p:grpSpPr>
            <p:cxnSp>
              <p:nvCxnSpPr>
                <p:cNvPr id="192" name="Straight Arrow Connector 191">
                  <a:extLst>
                    <a:ext uri="{FF2B5EF4-FFF2-40B4-BE49-F238E27FC236}">
                      <a16:creationId xmlns:a16="http://schemas.microsoft.com/office/drawing/2014/main" id="{ECF74AD7-742B-2BEC-B79F-1DEA9889172B}"/>
                    </a:ext>
                  </a:extLst>
                </p:cNvPr>
                <p:cNvCxnSpPr/>
                <p:nvPr/>
              </p:nvCxnSpPr>
              <p:spPr>
                <a:xfrm>
                  <a:off x="2390857" y="2542155"/>
                  <a:ext cx="8275" cy="2588338"/>
                </a:xfrm>
                <a:prstGeom prst="straightConnector1">
                  <a:avLst/>
                </a:prstGeom>
                <a:ln w="1587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3" name="Arc 192">
                  <a:extLst>
                    <a:ext uri="{FF2B5EF4-FFF2-40B4-BE49-F238E27FC236}">
                      <a16:creationId xmlns:a16="http://schemas.microsoft.com/office/drawing/2014/main" id="{73986E32-A0D3-E38D-CFEB-254359B83ED7}"/>
                    </a:ext>
                  </a:extLst>
                </p:cNvPr>
                <p:cNvSpPr/>
                <p:nvPr/>
              </p:nvSpPr>
              <p:spPr>
                <a:xfrm rot="10800000">
                  <a:off x="2392280" y="2538025"/>
                  <a:ext cx="610888" cy="610785"/>
                </a:xfrm>
                <a:prstGeom prst="arc">
                  <a:avLst/>
                </a:prstGeom>
                <a:ln w="15875">
                  <a:solidFill>
                    <a:schemeClr val="tx1"/>
                  </a:solidFill>
                  <a:head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nb-NO"/>
                </a:p>
              </p:txBody>
            </p:sp>
          </p:grpSp>
          <p:sp>
            <p:nvSpPr>
              <p:cNvPr id="194" name="Arc 193">
                <a:extLst>
                  <a:ext uri="{FF2B5EF4-FFF2-40B4-BE49-F238E27FC236}">
                    <a16:creationId xmlns:a16="http://schemas.microsoft.com/office/drawing/2014/main" id="{FB5B93D5-F4EA-A62D-9E28-4D33716C4EF4}"/>
                  </a:ext>
                </a:extLst>
              </p:cNvPr>
              <p:cNvSpPr/>
              <p:nvPr/>
            </p:nvSpPr>
            <p:spPr>
              <a:xfrm rot="10800000">
                <a:off x="2404254" y="3821995"/>
                <a:ext cx="610888" cy="610785"/>
              </a:xfrm>
              <a:prstGeom prst="arc">
                <a:avLst/>
              </a:prstGeom>
              <a:ln w="15875">
                <a:solidFill>
                  <a:schemeClr val="tx1"/>
                </a:solidFill>
                <a:head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nb-NO" dirty="0"/>
              </a:p>
            </p:txBody>
          </p:sp>
        </p:grp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ECA77CB1-24E3-E002-96B8-3ADBB76A6E67}"/>
                </a:ext>
              </a:extLst>
            </p:cNvPr>
            <p:cNvGrpSpPr/>
            <p:nvPr/>
          </p:nvGrpSpPr>
          <p:grpSpPr>
            <a:xfrm>
              <a:off x="1886382" y="8141918"/>
              <a:ext cx="1168441" cy="1160184"/>
              <a:chOff x="5026509" y="2782332"/>
              <a:chExt cx="1793051" cy="1780380"/>
            </a:xfrm>
          </p:grpSpPr>
          <p:pic>
            <p:nvPicPr>
              <p:cNvPr id="3" name="Bilde 1">
                <a:extLst>
                  <a:ext uri="{FF2B5EF4-FFF2-40B4-BE49-F238E27FC236}">
                    <a16:creationId xmlns:a16="http://schemas.microsoft.com/office/drawing/2014/main" id="{46CE6DD9-1083-C086-9315-FAAF2A53342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026509" y="27823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4" name="Bilde 1">
                <a:extLst>
                  <a:ext uri="{FF2B5EF4-FFF2-40B4-BE49-F238E27FC236}">
                    <a16:creationId xmlns:a16="http://schemas.microsoft.com/office/drawing/2014/main" id="{82A2EB55-F320-9D27-5888-3318E99032B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178909" y="29347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5" name="Bilde 1">
                <a:extLst>
                  <a:ext uri="{FF2B5EF4-FFF2-40B4-BE49-F238E27FC236}">
                    <a16:creationId xmlns:a16="http://schemas.microsoft.com/office/drawing/2014/main" id="{0DA58CB3-3430-D1D4-6F8E-F080A2F4DB5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331309" y="30871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6" name="Bilde 1">
                <a:extLst>
                  <a:ext uri="{FF2B5EF4-FFF2-40B4-BE49-F238E27FC236}">
                    <a16:creationId xmlns:a16="http://schemas.microsoft.com/office/drawing/2014/main" id="{7BEC57D2-3E42-AF04-AA3B-28C69804403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483709" y="32395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7" name="Bilde 1">
                <a:extLst>
                  <a:ext uri="{FF2B5EF4-FFF2-40B4-BE49-F238E27FC236}">
                    <a16:creationId xmlns:a16="http://schemas.microsoft.com/office/drawing/2014/main" id="{232DB0AA-63A7-03EC-6D4C-ACD3642CD29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636109" y="33919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8" name="Bilde 1">
                <a:extLst>
                  <a:ext uri="{FF2B5EF4-FFF2-40B4-BE49-F238E27FC236}">
                    <a16:creationId xmlns:a16="http://schemas.microsoft.com/office/drawing/2014/main" id="{533012F2-1E0E-036D-8777-47EF87FC4E7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788509" y="35443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9" name="Bilde 1">
                <a:extLst>
                  <a:ext uri="{FF2B5EF4-FFF2-40B4-BE49-F238E27FC236}">
                    <a16:creationId xmlns:a16="http://schemas.microsoft.com/office/drawing/2014/main" id="{2C99F548-88D5-CB11-9513-B39327717D0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940909" y="36967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0" name="Bilde 1">
                <a:extLst>
                  <a:ext uri="{FF2B5EF4-FFF2-40B4-BE49-F238E27FC236}">
                    <a16:creationId xmlns:a16="http://schemas.microsoft.com/office/drawing/2014/main" id="{E925326B-0943-EAF0-C939-D72FAAC735D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093309" y="3849132"/>
                <a:ext cx="573851" cy="561180"/>
              </a:xfrm>
              <a:prstGeom prst="rect">
                <a:avLst/>
              </a:prstGeom>
            </p:spPr>
          </p:pic>
          <p:pic>
            <p:nvPicPr>
              <p:cNvPr id="11" name="Bilde 1">
                <a:extLst>
                  <a:ext uri="{FF2B5EF4-FFF2-40B4-BE49-F238E27FC236}">
                    <a16:creationId xmlns:a16="http://schemas.microsoft.com/office/drawing/2014/main" id="{18DA0AEA-8B6C-C73A-6509-D1350A4A931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245709" y="4001532"/>
                <a:ext cx="573851" cy="561180"/>
              </a:xfrm>
              <a:prstGeom prst="rect">
                <a:avLst/>
              </a:prstGeom>
            </p:spPr>
          </p:pic>
        </p:grp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368D1C1D-2CFD-AC1F-2124-0D4AE080DB92}"/>
                </a:ext>
              </a:extLst>
            </p:cNvPr>
            <p:cNvSpPr txBox="1"/>
            <p:nvPr/>
          </p:nvSpPr>
          <p:spPr>
            <a:xfrm>
              <a:off x="3077937" y="8382000"/>
              <a:ext cx="2510147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For nine patients, follow-up MRIs performed a year or later after brain abscess surgery were </a:t>
              </a:r>
              <a:r>
                <a:rPr lang="en-US" sz="1200" dirty="0" smtClean="0"/>
                <a:t>available for evaluation of structural long-term effects of brain abscess.</a:t>
              </a:r>
              <a:endParaRPr lang="nb-NO" sz="1200" dirty="0"/>
            </a:p>
          </p:txBody>
        </p: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88F05834-1610-689C-ECEB-18FB568AAC36}"/>
                </a:ext>
              </a:extLst>
            </p:cNvPr>
            <p:cNvCxnSpPr/>
            <p:nvPr/>
          </p:nvCxnSpPr>
          <p:spPr>
            <a:xfrm>
              <a:off x="2913371" y="7025255"/>
              <a:ext cx="8275" cy="1656000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5460096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463b6811-b0a4-4b2a-b932-72c4c970c5d2}" enabled="0" method="" siteId="{463b6811-b0a4-4b2a-b932-72c4c970c5d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961</TotalTime>
  <Words>206</Words>
  <Application>Microsoft Office PowerPoint</Application>
  <PresentationFormat>A4 (210 x 297 mm)</PresentationFormat>
  <Paragraphs>18</Paragraphs>
  <Slides>2</Slides>
  <Notes>0</Notes>
  <HiddenSlides>0</HiddenSlides>
  <MMClips>0</MMClips>
  <ScaleCrop>false</ScaleCrop>
  <HeadingPairs>
    <vt:vector size="6" baseType="variant">
      <vt:variant>
        <vt:lpstr>Brukte skrifter</vt:lpstr>
      </vt:variant>
      <vt:variant>
        <vt:i4>4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Office Theme</vt:lpstr>
      <vt:lpstr>PowerPoint-presentasjon</vt:lpstr>
      <vt:lpstr>PowerPoint-presentasj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jørnar Hassel</dc:creator>
  <cp:lastModifiedBy>Mona-Elisabeth Rootwelt-Revheim</cp:lastModifiedBy>
  <cp:revision>3</cp:revision>
  <dcterms:created xsi:type="dcterms:W3CDTF">2024-05-14T08:22:15Z</dcterms:created>
  <dcterms:modified xsi:type="dcterms:W3CDTF">2024-09-01T14:13:32Z</dcterms:modified>
</cp:coreProperties>
</file>